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1112500" cy="140398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422" userDrawn="1">
          <p15:clr>
            <a:srgbClr val="A4A3A4"/>
          </p15:clr>
        </p15:guide>
        <p15:guide id="2" pos="352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66" d="100"/>
          <a:sy n="66" d="100"/>
        </p:scale>
        <p:origin x="768" y="38"/>
      </p:cViewPr>
      <p:guideLst>
        <p:guide orient="horz" pos="4422"/>
        <p:guide pos="352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E:\&#39033;&#30446;&#24605;&#36335;\raspberry\&#34507;&#30333;&#32452;\raspberry&#26368;&#32456;&#25253;&#21578;\S9303TQ_82198\S9303TQ\analysis\Kegg%20enrich\GY_BG%20KEGG_pathway_enrichment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.xlsx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3.xlsx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4.xlsx"/><Relationship Id="rId1" Type="http://schemas.openxmlformats.org/officeDocument/2006/relationships/themeOverride" Target="../theme/themeOverrid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10"/>
    </mc:Choice>
    <mc:Fallback>
      <c:style val="10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50124500642271141"/>
          <c:y val="0.16889063867016624"/>
          <c:w val="0.4637494559517632"/>
          <c:h val="0.74069672837663403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FF0000"/>
            </a:solidFill>
          </c:spPr>
          <c:invertIfNegative val="0"/>
          <c:cat>
            <c:strRef>
              <c:f>Up!$A$2:$A$6</c:f>
              <c:strCache>
                <c:ptCount val="5"/>
                <c:pt idx="0">
                  <c:v>Ribosome</c:v>
                </c:pt>
                <c:pt idx="1">
                  <c:v>Cutin, suberine and wax biosynthesis</c:v>
                </c:pt>
                <c:pt idx="2">
                  <c:v>Fatty acid biosynthesis</c:v>
                </c:pt>
                <c:pt idx="3">
                  <c:v>Biotin metabolism</c:v>
                </c:pt>
                <c:pt idx="4">
                  <c:v>Protein processing in endoplasmic reticulum</c:v>
                </c:pt>
              </c:strCache>
            </c:strRef>
          </c:cat>
          <c:val>
            <c:numRef>
              <c:f>Up!$H$2:$H$6</c:f>
              <c:numCache>
                <c:formatCode>General</c:formatCode>
                <c:ptCount val="5"/>
                <c:pt idx="0">
                  <c:v>11.36</c:v>
                </c:pt>
                <c:pt idx="1">
                  <c:v>4.97</c:v>
                </c:pt>
                <c:pt idx="2">
                  <c:v>3.26</c:v>
                </c:pt>
                <c:pt idx="3">
                  <c:v>1.84</c:v>
                </c:pt>
                <c:pt idx="4">
                  <c:v>1.6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458-4B80-B706-E87FE26CCEB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245272576"/>
        <c:axId val="245274112"/>
      </c:barChart>
      <c:catAx>
        <c:axId val="245272576"/>
        <c:scaling>
          <c:orientation val="maxMin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 rot="0" anchor="t" anchorCtr="0"/>
          <a:lstStyle/>
          <a:p>
            <a:pPr>
              <a:defRPr sz="800"/>
            </a:pPr>
            <a:endParaRPr lang="zh-CN"/>
          </a:p>
        </c:txPr>
        <c:crossAx val="245274112"/>
        <c:crosses val="autoZero"/>
        <c:auto val="1"/>
        <c:lblAlgn val="ctr"/>
        <c:lblOffset val="100"/>
        <c:tickLblSkip val="1"/>
        <c:noMultiLvlLbl val="0"/>
      </c:catAx>
      <c:valAx>
        <c:axId val="245274112"/>
        <c:scaling>
          <c:orientation val="minMax"/>
          <c:max val="12"/>
          <c:min val="0"/>
        </c:scaling>
        <c:delete val="0"/>
        <c:axPos val="t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-log10(P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245272576"/>
        <c:crosses val="autoZero"/>
        <c:crossBetween val="between"/>
        <c:majorUnit val="3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zh-CN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10"/>
    </mc:Choice>
    <mc:Fallback>
      <c:style val="10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48140434852665159"/>
          <c:y val="0.16186362714247299"/>
          <c:w val="0.48891311030686718"/>
          <c:h val="0.81852183709504844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0070C0"/>
            </a:solidFill>
          </c:spPr>
          <c:invertIfNegative val="0"/>
          <c:cat>
            <c:strRef>
              <c:f>Down!$A$2:$A$10</c:f>
              <c:strCache>
                <c:ptCount val="9"/>
                <c:pt idx="0">
                  <c:v>Flavonoid biosynthesis</c:v>
                </c:pt>
                <c:pt idx="1">
                  <c:v>Phenylpropanoid biosynthesis</c:v>
                </c:pt>
                <c:pt idx="2">
                  <c:v>Spliceosome</c:v>
                </c:pt>
                <c:pt idx="3">
                  <c:v>Stilbenoid, diarylheptanoid and gingerol biosynthesis</c:v>
                </c:pt>
                <c:pt idx="4">
                  <c:v>RNA transport</c:v>
                </c:pt>
                <c:pt idx="5">
                  <c:v>Biosynthesis of secondary metabolites - unclassified</c:v>
                </c:pt>
                <c:pt idx="6">
                  <c:v>Plant-pathogen interaction</c:v>
                </c:pt>
                <c:pt idx="7">
                  <c:v>Biosynthesis of secondary metabolites - other antibiotics</c:v>
                </c:pt>
                <c:pt idx="8">
                  <c:v>Phenylalanine, tyrosine and tryptophan biosynthesis</c:v>
                </c:pt>
              </c:strCache>
            </c:strRef>
          </c:cat>
          <c:val>
            <c:numRef>
              <c:f>Down!$H$2:$H$10</c:f>
              <c:numCache>
                <c:formatCode>General</c:formatCode>
                <c:ptCount val="9"/>
                <c:pt idx="0">
                  <c:v>8.1999999999999993</c:v>
                </c:pt>
                <c:pt idx="1">
                  <c:v>7.45</c:v>
                </c:pt>
                <c:pt idx="2">
                  <c:v>4.8099999999999996</c:v>
                </c:pt>
                <c:pt idx="3">
                  <c:v>3.34</c:v>
                </c:pt>
                <c:pt idx="4">
                  <c:v>2.34</c:v>
                </c:pt>
                <c:pt idx="5">
                  <c:v>2.2999999999999998</c:v>
                </c:pt>
                <c:pt idx="6">
                  <c:v>2.02</c:v>
                </c:pt>
                <c:pt idx="7">
                  <c:v>1.86</c:v>
                </c:pt>
                <c:pt idx="8">
                  <c:v>1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5A4-404B-83F1-F480B0248A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10728704"/>
        <c:axId val="110730240"/>
      </c:barChart>
      <c:catAx>
        <c:axId val="110728704"/>
        <c:scaling>
          <c:orientation val="maxMin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 anchor="t" anchorCtr="0"/>
          <a:lstStyle/>
          <a:p>
            <a:pPr algn="ctr">
              <a:defRPr lang="zh-CN" altLang="en-US" sz="800" b="0" i="0" u="none" strike="noStrike" kern="1200" baseline="0">
                <a:solidFill>
                  <a:sysClr val="windowText" lastClr="000000"/>
                </a:solidFill>
                <a:latin typeface="Times New Roman" pitchFamily="18" charset="0"/>
                <a:ea typeface="+mn-ea"/>
                <a:cs typeface="Times New Roman" pitchFamily="18" charset="0"/>
              </a:defRPr>
            </a:pPr>
            <a:endParaRPr lang="zh-CN"/>
          </a:p>
        </c:txPr>
        <c:crossAx val="110730240"/>
        <c:crosses val="autoZero"/>
        <c:auto val="1"/>
        <c:lblAlgn val="ctr"/>
        <c:lblOffset val="100"/>
        <c:noMultiLvlLbl val="0"/>
      </c:catAx>
      <c:valAx>
        <c:axId val="110730240"/>
        <c:scaling>
          <c:orientation val="minMax"/>
        </c:scaling>
        <c:delete val="0"/>
        <c:axPos val="t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-log10(P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110728704"/>
        <c:crosses val="autoZero"/>
        <c:crossBetween val="between"/>
        <c:majorUnit val="3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zh-CN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10"/>
    </mc:Choice>
    <mc:Fallback>
      <c:style val="10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46715425013465101"/>
          <c:y val="0.15651577315423582"/>
          <c:w val="0.49420188627835537"/>
          <c:h val="0.7712777838254089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FF0000"/>
            </a:solidFill>
          </c:spPr>
          <c:invertIfNegative val="0"/>
          <c:cat>
            <c:strRef>
              <c:f>Up!$A$2:$A$7</c:f>
              <c:strCache>
                <c:ptCount val="6"/>
                <c:pt idx="0">
                  <c:v>Ribosome</c:v>
                </c:pt>
                <c:pt idx="1">
                  <c:v>Pyruvate metabolism</c:v>
                </c:pt>
                <c:pt idx="2">
                  <c:v>Fatty acid biosynthesis</c:v>
                </c:pt>
                <c:pt idx="3">
                  <c:v>Cutin, suberine and wax biosynthesis</c:v>
                </c:pt>
                <c:pt idx="4">
                  <c:v>Carotenoid biosynthesis</c:v>
                </c:pt>
                <c:pt idx="5">
                  <c:v>Carbon fixation in photosynthetic organisms</c:v>
                </c:pt>
              </c:strCache>
            </c:strRef>
          </c:cat>
          <c:val>
            <c:numRef>
              <c:f>Up!$H$2:$H$7</c:f>
              <c:numCache>
                <c:formatCode>General</c:formatCode>
                <c:ptCount val="6"/>
                <c:pt idx="0">
                  <c:v>20.100000000000001</c:v>
                </c:pt>
                <c:pt idx="1">
                  <c:v>2.5299999999999998</c:v>
                </c:pt>
                <c:pt idx="2">
                  <c:v>2.4900000000000002</c:v>
                </c:pt>
                <c:pt idx="3">
                  <c:v>2.37</c:v>
                </c:pt>
                <c:pt idx="4">
                  <c:v>2.14</c:v>
                </c:pt>
                <c:pt idx="5">
                  <c:v>1.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4D8-4A6C-B866-55EAC0AB5F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195648512"/>
        <c:axId val="247554816"/>
      </c:barChart>
      <c:catAx>
        <c:axId val="195648512"/>
        <c:scaling>
          <c:orientation val="maxMin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zh-CN"/>
          </a:p>
        </c:txPr>
        <c:crossAx val="247554816"/>
        <c:crosses val="autoZero"/>
        <c:auto val="1"/>
        <c:lblAlgn val="ctr"/>
        <c:lblOffset val="100"/>
        <c:noMultiLvlLbl val="0"/>
      </c:catAx>
      <c:valAx>
        <c:axId val="247554816"/>
        <c:scaling>
          <c:orientation val="minMax"/>
          <c:max val="20"/>
        </c:scaling>
        <c:delete val="0"/>
        <c:axPos val="t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-log10(P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195648512"/>
        <c:crosses val="autoZero"/>
        <c:crossBetween val="between"/>
        <c:majorUnit val="5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zh-CN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10"/>
    </mc:Choice>
    <mc:Fallback>
      <c:style val="10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51068119424676395"/>
          <c:y val="0.16732419023126291"/>
          <c:w val="0.45012407922553238"/>
          <c:h val="0.80685151690027923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0070C0"/>
            </a:solidFill>
          </c:spPr>
          <c:invertIfNegative val="0"/>
          <c:cat>
            <c:strRef>
              <c:f>Down!$A$2:$A$12</c:f>
              <c:strCache>
                <c:ptCount val="11"/>
                <c:pt idx="0">
                  <c:v>Photosynthesis</c:v>
                </c:pt>
                <c:pt idx="1">
                  <c:v>Photosynthesis - antenna proteins</c:v>
                </c:pt>
                <c:pt idx="2">
                  <c:v>Phenylpropanoid biosynthesis</c:v>
                </c:pt>
                <c:pt idx="3">
                  <c:v>Flavonoid biosynthesis</c:v>
                </c:pt>
                <c:pt idx="4">
                  <c:v>Stilbenoid, diarylheptanoid and gingerol biosynthesis</c:v>
                </c:pt>
                <c:pt idx="5">
                  <c:v>Phenylalanine, tyrosine and tryptophan biosynthesis</c:v>
                </c:pt>
                <c:pt idx="6">
                  <c:v>Biosynthesis of secondary metabolites - unclassified</c:v>
                </c:pt>
                <c:pt idx="7">
                  <c:v>Linoleic acid metabolism</c:v>
                </c:pt>
                <c:pt idx="8">
                  <c:v>Biosynthesis of secondary metabolites - other antibiotics</c:v>
                </c:pt>
                <c:pt idx="9">
                  <c:v>Ubiquinone and other terpenoid-quinone biosynthesis</c:v>
                </c:pt>
                <c:pt idx="10">
                  <c:v>One carbon pool by folate</c:v>
                </c:pt>
              </c:strCache>
            </c:strRef>
          </c:cat>
          <c:val>
            <c:numRef>
              <c:f>Down!$H$2:$H$12</c:f>
              <c:numCache>
                <c:formatCode>General</c:formatCode>
                <c:ptCount val="11"/>
                <c:pt idx="0">
                  <c:v>12.58</c:v>
                </c:pt>
                <c:pt idx="1">
                  <c:v>12.12</c:v>
                </c:pt>
                <c:pt idx="2">
                  <c:v>8.57</c:v>
                </c:pt>
                <c:pt idx="3">
                  <c:v>8.35</c:v>
                </c:pt>
                <c:pt idx="4">
                  <c:v>3.78</c:v>
                </c:pt>
                <c:pt idx="5">
                  <c:v>3.6</c:v>
                </c:pt>
                <c:pt idx="6">
                  <c:v>2.9</c:v>
                </c:pt>
                <c:pt idx="7">
                  <c:v>2.9</c:v>
                </c:pt>
                <c:pt idx="8">
                  <c:v>1.7</c:v>
                </c:pt>
                <c:pt idx="9">
                  <c:v>1.58</c:v>
                </c:pt>
                <c:pt idx="10">
                  <c:v>1.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943-426C-85B2-4B8E0FCE8A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247771904"/>
        <c:axId val="247773440"/>
      </c:barChart>
      <c:catAx>
        <c:axId val="247771904"/>
        <c:scaling>
          <c:orientation val="maxMin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zh-CN"/>
          </a:p>
        </c:txPr>
        <c:crossAx val="247773440"/>
        <c:crosses val="autoZero"/>
        <c:auto val="1"/>
        <c:lblAlgn val="ctr"/>
        <c:lblOffset val="100"/>
        <c:noMultiLvlLbl val="0"/>
      </c:catAx>
      <c:valAx>
        <c:axId val="247773440"/>
        <c:scaling>
          <c:orientation val="minMax"/>
        </c:scaling>
        <c:delete val="0"/>
        <c:axPos val="t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-log10(P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247771904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zh-CN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10"/>
    </mc:Choice>
    <mc:Fallback>
      <c:style val="10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48310081665575244"/>
          <c:y val="0.16571268790264854"/>
          <c:w val="0.47907459799201163"/>
          <c:h val="0.81248478883321407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FF0000"/>
            </a:solidFill>
          </c:spPr>
          <c:invertIfNegative val="0"/>
          <c:cat>
            <c:strRef>
              <c:f>Up!$A$2:$A$4</c:f>
              <c:strCache>
                <c:ptCount val="3"/>
                <c:pt idx="0">
                  <c:v>Ribosome</c:v>
                </c:pt>
                <c:pt idx="1">
                  <c:v>Carotenoid biosynthesis</c:v>
                </c:pt>
                <c:pt idx="2">
                  <c:v>Biosynthesis of unsaturated fatty acids</c:v>
                </c:pt>
              </c:strCache>
            </c:strRef>
          </c:cat>
          <c:val>
            <c:numRef>
              <c:f>Up!$H$2:$H$4</c:f>
              <c:numCache>
                <c:formatCode>General</c:formatCode>
                <c:ptCount val="3"/>
                <c:pt idx="0">
                  <c:v>27.66</c:v>
                </c:pt>
                <c:pt idx="1">
                  <c:v>2.95</c:v>
                </c:pt>
                <c:pt idx="2">
                  <c:v>2.4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75A-477C-A4FB-0EB7FEB7F9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247769344"/>
        <c:axId val="254967808"/>
      </c:barChart>
      <c:catAx>
        <c:axId val="247769344"/>
        <c:scaling>
          <c:orientation val="maxMin"/>
        </c:scaling>
        <c:delete val="0"/>
        <c:axPos val="l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>
                <a:latin typeface="Times New Roman" pitchFamily="18" charset="0"/>
                <a:cs typeface="Times New Roman" pitchFamily="18" charset="0"/>
              </a:defRPr>
            </a:pPr>
            <a:endParaRPr lang="zh-CN"/>
          </a:p>
        </c:txPr>
        <c:crossAx val="254967808"/>
        <c:crosses val="autoZero"/>
        <c:auto val="1"/>
        <c:lblAlgn val="ctr"/>
        <c:lblOffset val="100"/>
        <c:noMultiLvlLbl val="0"/>
      </c:catAx>
      <c:valAx>
        <c:axId val="254967808"/>
        <c:scaling>
          <c:orientation val="minMax"/>
          <c:max val="32"/>
          <c:min val="0"/>
        </c:scaling>
        <c:delete val="0"/>
        <c:axPos val="t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-log10(P)</a:t>
                </a:r>
              </a:p>
            </c:rich>
          </c:tx>
          <c:layout>
            <c:manualLayout>
              <c:xMode val="edge"/>
              <c:yMode val="edge"/>
              <c:x val="0.58109051322734673"/>
              <c:y val="5.1632963493199813E-3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247769344"/>
        <c:crosses val="autoZero"/>
        <c:crossBetween val="between"/>
        <c:majorUnit val="8"/>
      </c:valAx>
    </c:plotArea>
    <c:plotVisOnly val="1"/>
    <c:dispBlanksAs val="gap"/>
    <c:showDLblsOverMax val="0"/>
  </c:chart>
  <c:spPr>
    <a:noFill/>
    <a:ln>
      <a:noFill/>
    </a:ln>
  </c:sp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10"/>
    </mc:Choice>
    <mc:Fallback>
      <c:style val="10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46075869605122116"/>
          <c:y val="0.23672859574135463"/>
          <c:w val="0.49767959522406285"/>
          <c:h val="0.72817293241097025"/>
        </c:manualLayout>
      </c:layout>
      <c:barChart>
        <c:barDir val="bar"/>
        <c:grouping val="clustered"/>
        <c:varyColors val="0"/>
        <c:ser>
          <c:idx val="0"/>
          <c:order val="0"/>
          <c:spPr>
            <a:solidFill>
              <a:srgbClr val="0070C0"/>
            </a:solidFill>
          </c:spPr>
          <c:invertIfNegative val="0"/>
          <c:cat>
            <c:strRef>
              <c:f>Down!$A$2:$A$21</c:f>
              <c:strCache>
                <c:ptCount val="20"/>
                <c:pt idx="0">
                  <c:v>Photosynthesis</c:v>
                </c:pt>
                <c:pt idx="1">
                  <c:v>Photosynthesis - antenna proteins</c:v>
                </c:pt>
                <c:pt idx="2">
                  <c:v>Flavonoid biosynthesis</c:v>
                </c:pt>
                <c:pt idx="3">
                  <c:v>Phenylpropanoid biosynthesis</c:v>
                </c:pt>
                <c:pt idx="4">
                  <c:v>Phenylalanine, tyrosine and tryptophan biosynthesis</c:v>
                </c:pt>
                <c:pt idx="5">
                  <c:v>Linoleic acid metabolism</c:v>
                </c:pt>
                <c:pt idx="6">
                  <c:v>Biosynthesis of secondary metabolites - unclassified</c:v>
                </c:pt>
                <c:pt idx="7">
                  <c:v>Glutathione metabolism</c:v>
                </c:pt>
                <c:pt idx="8">
                  <c:v>Carbon fixation in photosynthetic organisms</c:v>
                </c:pt>
                <c:pt idx="9">
                  <c:v>Ubiquinone and other terpenoid-quinone biosynthesis</c:v>
                </c:pt>
                <c:pt idx="10">
                  <c:v>Stilbenoid, diarylheptanoid and gingerol biosynthesis</c:v>
                </c:pt>
                <c:pt idx="11">
                  <c:v>Glyoxylate and dicarboxylate metabolism</c:v>
                </c:pt>
                <c:pt idx="12">
                  <c:v>Alanine, aspartate and glutamate metabolism</c:v>
                </c:pt>
                <c:pt idx="13">
                  <c:v>Oxidative phosphorylation</c:v>
                </c:pt>
                <c:pt idx="14">
                  <c:v>alpha-Linolenic acid metabolism</c:v>
                </c:pt>
                <c:pt idx="15">
                  <c:v>Glycine, serine and threonine metabolism</c:v>
                </c:pt>
                <c:pt idx="16">
                  <c:v>Biosynthesis of secondary metabolites - other antibiotics</c:v>
                </c:pt>
                <c:pt idx="17">
                  <c:v>Tropane, piperidine and pyridine alkaloid biosynthesis</c:v>
                </c:pt>
                <c:pt idx="18">
                  <c:v>Phenylalanine metabolism</c:v>
                </c:pt>
                <c:pt idx="19">
                  <c:v>Nitrogen metabolism</c:v>
                </c:pt>
              </c:strCache>
            </c:strRef>
          </c:cat>
          <c:val>
            <c:numRef>
              <c:f>Down!$H$2:$H$21</c:f>
              <c:numCache>
                <c:formatCode>General</c:formatCode>
                <c:ptCount val="20"/>
                <c:pt idx="0">
                  <c:v>22.85</c:v>
                </c:pt>
                <c:pt idx="1">
                  <c:v>11.76</c:v>
                </c:pt>
                <c:pt idx="2">
                  <c:v>5.88</c:v>
                </c:pt>
                <c:pt idx="3">
                  <c:v>5.44</c:v>
                </c:pt>
                <c:pt idx="4">
                  <c:v>4.74</c:v>
                </c:pt>
                <c:pt idx="5">
                  <c:v>3.8</c:v>
                </c:pt>
                <c:pt idx="6">
                  <c:v>2.78</c:v>
                </c:pt>
                <c:pt idx="7">
                  <c:v>2.2599999999999998</c:v>
                </c:pt>
                <c:pt idx="8">
                  <c:v>2.1</c:v>
                </c:pt>
                <c:pt idx="9">
                  <c:v>2</c:v>
                </c:pt>
                <c:pt idx="10">
                  <c:v>1.97</c:v>
                </c:pt>
                <c:pt idx="11">
                  <c:v>1.94</c:v>
                </c:pt>
                <c:pt idx="12">
                  <c:v>1.91</c:v>
                </c:pt>
                <c:pt idx="13">
                  <c:v>1.84</c:v>
                </c:pt>
                <c:pt idx="14">
                  <c:v>1.75</c:v>
                </c:pt>
                <c:pt idx="15">
                  <c:v>1.75</c:v>
                </c:pt>
                <c:pt idx="16">
                  <c:v>1.64</c:v>
                </c:pt>
                <c:pt idx="17">
                  <c:v>1.46</c:v>
                </c:pt>
                <c:pt idx="18">
                  <c:v>1.39</c:v>
                </c:pt>
                <c:pt idx="19">
                  <c:v>1.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214-4F89-BCB3-A23D5B1426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255062016"/>
        <c:axId val="255063552"/>
      </c:barChart>
      <c:catAx>
        <c:axId val="255062016"/>
        <c:scaling>
          <c:orientation val="maxMin"/>
        </c:scaling>
        <c:delete val="0"/>
        <c:axPos val="l"/>
        <c:numFmt formatCode="General" sourceLinked="0"/>
        <c:majorTickMark val="out"/>
        <c:minorTickMark val="none"/>
        <c:tickLblPos val="nextTo"/>
        <c:crossAx val="255063552"/>
        <c:crosses val="autoZero"/>
        <c:auto val="1"/>
        <c:lblAlgn val="ctr"/>
        <c:lblOffset val="100"/>
        <c:tickLblSkip val="1"/>
        <c:noMultiLvlLbl val="0"/>
      </c:catAx>
      <c:valAx>
        <c:axId val="255063552"/>
        <c:scaling>
          <c:orientation val="minMax"/>
        </c:scaling>
        <c:delete val="0"/>
        <c:axPos val="t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-log10(P)</a:t>
                </a: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crossAx val="255062016"/>
        <c:crosses val="autoZero"/>
        <c:crossBetween val="between"/>
      </c:valAx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zh-CN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33438" y="2297726"/>
            <a:ext cx="9445625" cy="4887948"/>
          </a:xfrm>
        </p:spPr>
        <p:txBody>
          <a:bodyPr anchor="b"/>
          <a:lstStyle>
            <a:lvl1pPr algn="ctr">
              <a:defRPr sz="729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89063" y="7374172"/>
            <a:ext cx="8334375" cy="3389713"/>
          </a:xfrm>
        </p:spPr>
        <p:txBody>
          <a:bodyPr/>
          <a:lstStyle>
            <a:lvl1pPr marL="0" indent="0" algn="ctr">
              <a:buNone/>
              <a:defRPr sz="2917"/>
            </a:lvl1pPr>
            <a:lvl2pPr marL="555635" indent="0" algn="ctr">
              <a:buNone/>
              <a:defRPr sz="2431"/>
            </a:lvl2pPr>
            <a:lvl3pPr marL="1111270" indent="0" algn="ctr">
              <a:buNone/>
              <a:defRPr sz="2188"/>
            </a:lvl3pPr>
            <a:lvl4pPr marL="1666905" indent="0" algn="ctr">
              <a:buNone/>
              <a:defRPr sz="1944"/>
            </a:lvl4pPr>
            <a:lvl5pPr marL="2222541" indent="0" algn="ctr">
              <a:buNone/>
              <a:defRPr sz="1944"/>
            </a:lvl5pPr>
            <a:lvl6pPr marL="2778176" indent="0" algn="ctr">
              <a:buNone/>
              <a:defRPr sz="1944"/>
            </a:lvl6pPr>
            <a:lvl7pPr marL="3333811" indent="0" algn="ctr">
              <a:buNone/>
              <a:defRPr sz="1944"/>
            </a:lvl7pPr>
            <a:lvl8pPr marL="3889446" indent="0" algn="ctr">
              <a:buNone/>
              <a:defRPr sz="1944"/>
            </a:lvl8pPr>
            <a:lvl9pPr marL="4445081" indent="0" algn="ctr">
              <a:buNone/>
              <a:defRPr sz="1944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6BC2C-ACBC-4160-801B-9E12759999D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1BC12-CD82-486C-8CA3-6C40BA0C40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2794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6BC2C-ACBC-4160-801B-9E12759999D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1BC12-CD82-486C-8CA3-6C40BA0C40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9107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952383" y="747492"/>
            <a:ext cx="2396133" cy="11898124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63985" y="747492"/>
            <a:ext cx="7049492" cy="11898124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6BC2C-ACBC-4160-801B-9E12759999D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1BC12-CD82-486C-8CA3-6C40BA0C40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65278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6BC2C-ACBC-4160-801B-9E12759999D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1BC12-CD82-486C-8CA3-6C40BA0C40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7598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8197" y="3500216"/>
            <a:ext cx="9584531" cy="5840187"/>
          </a:xfrm>
        </p:spPr>
        <p:txBody>
          <a:bodyPr anchor="b"/>
          <a:lstStyle>
            <a:lvl1pPr>
              <a:defRPr sz="729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8197" y="9395654"/>
            <a:ext cx="9584531" cy="3071216"/>
          </a:xfrm>
        </p:spPr>
        <p:txBody>
          <a:bodyPr/>
          <a:lstStyle>
            <a:lvl1pPr marL="0" indent="0">
              <a:buNone/>
              <a:defRPr sz="2917">
                <a:solidFill>
                  <a:schemeClr val="tx1"/>
                </a:solidFill>
              </a:defRPr>
            </a:lvl1pPr>
            <a:lvl2pPr marL="555635" indent="0">
              <a:buNone/>
              <a:defRPr sz="2431">
                <a:solidFill>
                  <a:schemeClr val="tx1">
                    <a:tint val="75000"/>
                  </a:schemeClr>
                </a:solidFill>
              </a:defRPr>
            </a:lvl2pPr>
            <a:lvl3pPr marL="1111270" indent="0">
              <a:buNone/>
              <a:defRPr sz="2188">
                <a:solidFill>
                  <a:schemeClr val="tx1">
                    <a:tint val="75000"/>
                  </a:schemeClr>
                </a:solidFill>
              </a:defRPr>
            </a:lvl3pPr>
            <a:lvl4pPr marL="1666905" indent="0">
              <a:buNone/>
              <a:defRPr sz="1944">
                <a:solidFill>
                  <a:schemeClr val="tx1">
                    <a:tint val="75000"/>
                  </a:schemeClr>
                </a:solidFill>
              </a:defRPr>
            </a:lvl4pPr>
            <a:lvl5pPr marL="2222541" indent="0">
              <a:buNone/>
              <a:defRPr sz="1944">
                <a:solidFill>
                  <a:schemeClr val="tx1">
                    <a:tint val="75000"/>
                  </a:schemeClr>
                </a:solidFill>
              </a:defRPr>
            </a:lvl5pPr>
            <a:lvl6pPr marL="2778176" indent="0">
              <a:buNone/>
              <a:defRPr sz="1944">
                <a:solidFill>
                  <a:schemeClr val="tx1">
                    <a:tint val="75000"/>
                  </a:schemeClr>
                </a:solidFill>
              </a:defRPr>
            </a:lvl6pPr>
            <a:lvl7pPr marL="3333811" indent="0">
              <a:buNone/>
              <a:defRPr sz="1944">
                <a:solidFill>
                  <a:schemeClr val="tx1">
                    <a:tint val="75000"/>
                  </a:schemeClr>
                </a:solidFill>
              </a:defRPr>
            </a:lvl7pPr>
            <a:lvl8pPr marL="3889446" indent="0">
              <a:buNone/>
              <a:defRPr sz="1944">
                <a:solidFill>
                  <a:schemeClr val="tx1">
                    <a:tint val="75000"/>
                  </a:schemeClr>
                </a:solidFill>
              </a:defRPr>
            </a:lvl8pPr>
            <a:lvl9pPr marL="4445081" indent="0">
              <a:buNone/>
              <a:defRPr sz="19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6BC2C-ACBC-4160-801B-9E12759999D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1BC12-CD82-486C-8CA3-6C40BA0C40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885583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63984" y="3737460"/>
            <a:ext cx="4722813" cy="890815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25703" y="3737460"/>
            <a:ext cx="4722813" cy="890815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6BC2C-ACBC-4160-801B-9E12759999D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1BC12-CD82-486C-8CA3-6C40BA0C40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8119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5432" y="747495"/>
            <a:ext cx="9584531" cy="271372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5433" y="3441714"/>
            <a:ext cx="4701108" cy="1686731"/>
          </a:xfrm>
        </p:spPr>
        <p:txBody>
          <a:bodyPr anchor="b"/>
          <a:lstStyle>
            <a:lvl1pPr marL="0" indent="0">
              <a:buNone/>
              <a:defRPr sz="2917" b="1"/>
            </a:lvl1pPr>
            <a:lvl2pPr marL="555635" indent="0">
              <a:buNone/>
              <a:defRPr sz="2431" b="1"/>
            </a:lvl2pPr>
            <a:lvl3pPr marL="1111270" indent="0">
              <a:buNone/>
              <a:defRPr sz="2188" b="1"/>
            </a:lvl3pPr>
            <a:lvl4pPr marL="1666905" indent="0">
              <a:buNone/>
              <a:defRPr sz="1944" b="1"/>
            </a:lvl4pPr>
            <a:lvl5pPr marL="2222541" indent="0">
              <a:buNone/>
              <a:defRPr sz="1944" b="1"/>
            </a:lvl5pPr>
            <a:lvl6pPr marL="2778176" indent="0">
              <a:buNone/>
              <a:defRPr sz="1944" b="1"/>
            </a:lvl6pPr>
            <a:lvl7pPr marL="3333811" indent="0">
              <a:buNone/>
              <a:defRPr sz="1944" b="1"/>
            </a:lvl7pPr>
            <a:lvl8pPr marL="3889446" indent="0">
              <a:buNone/>
              <a:defRPr sz="1944" b="1"/>
            </a:lvl8pPr>
            <a:lvl9pPr marL="4445081" indent="0">
              <a:buNone/>
              <a:defRPr sz="194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65433" y="5128445"/>
            <a:ext cx="4701108" cy="754317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625704" y="3441714"/>
            <a:ext cx="4724260" cy="1686731"/>
          </a:xfrm>
        </p:spPr>
        <p:txBody>
          <a:bodyPr anchor="b"/>
          <a:lstStyle>
            <a:lvl1pPr marL="0" indent="0">
              <a:buNone/>
              <a:defRPr sz="2917" b="1"/>
            </a:lvl1pPr>
            <a:lvl2pPr marL="555635" indent="0">
              <a:buNone/>
              <a:defRPr sz="2431" b="1"/>
            </a:lvl2pPr>
            <a:lvl3pPr marL="1111270" indent="0">
              <a:buNone/>
              <a:defRPr sz="2188" b="1"/>
            </a:lvl3pPr>
            <a:lvl4pPr marL="1666905" indent="0">
              <a:buNone/>
              <a:defRPr sz="1944" b="1"/>
            </a:lvl4pPr>
            <a:lvl5pPr marL="2222541" indent="0">
              <a:buNone/>
              <a:defRPr sz="1944" b="1"/>
            </a:lvl5pPr>
            <a:lvl6pPr marL="2778176" indent="0">
              <a:buNone/>
              <a:defRPr sz="1944" b="1"/>
            </a:lvl6pPr>
            <a:lvl7pPr marL="3333811" indent="0">
              <a:buNone/>
              <a:defRPr sz="1944" b="1"/>
            </a:lvl7pPr>
            <a:lvl8pPr marL="3889446" indent="0">
              <a:buNone/>
              <a:defRPr sz="1944" b="1"/>
            </a:lvl8pPr>
            <a:lvl9pPr marL="4445081" indent="0">
              <a:buNone/>
              <a:defRPr sz="1944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625704" y="5128445"/>
            <a:ext cx="4724260" cy="754317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6BC2C-ACBC-4160-801B-9E12759999D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1BC12-CD82-486C-8CA3-6C40BA0C40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450608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6BC2C-ACBC-4160-801B-9E12759999D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1BC12-CD82-486C-8CA3-6C40BA0C40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98792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6BC2C-ACBC-4160-801B-9E12759999D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1BC12-CD82-486C-8CA3-6C40BA0C40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08183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5432" y="935990"/>
            <a:ext cx="3584070" cy="3275965"/>
          </a:xfrm>
        </p:spPr>
        <p:txBody>
          <a:bodyPr anchor="b"/>
          <a:lstStyle>
            <a:lvl1pPr>
              <a:defRPr sz="388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24260" y="2021482"/>
            <a:ext cx="5625703" cy="9977393"/>
          </a:xfrm>
        </p:spPr>
        <p:txBody>
          <a:bodyPr/>
          <a:lstStyle>
            <a:lvl1pPr>
              <a:defRPr sz="3889"/>
            </a:lvl1pPr>
            <a:lvl2pPr>
              <a:defRPr sz="3403"/>
            </a:lvl2pPr>
            <a:lvl3pPr>
              <a:defRPr sz="2917"/>
            </a:lvl3pPr>
            <a:lvl4pPr>
              <a:defRPr sz="2431"/>
            </a:lvl4pPr>
            <a:lvl5pPr>
              <a:defRPr sz="2431"/>
            </a:lvl5pPr>
            <a:lvl6pPr>
              <a:defRPr sz="2431"/>
            </a:lvl6pPr>
            <a:lvl7pPr>
              <a:defRPr sz="2431"/>
            </a:lvl7pPr>
            <a:lvl8pPr>
              <a:defRPr sz="2431"/>
            </a:lvl8pPr>
            <a:lvl9pPr>
              <a:defRPr sz="2431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65432" y="4211955"/>
            <a:ext cx="3584070" cy="7803168"/>
          </a:xfrm>
        </p:spPr>
        <p:txBody>
          <a:bodyPr/>
          <a:lstStyle>
            <a:lvl1pPr marL="0" indent="0">
              <a:buNone/>
              <a:defRPr sz="1944"/>
            </a:lvl1pPr>
            <a:lvl2pPr marL="555635" indent="0">
              <a:buNone/>
              <a:defRPr sz="1701"/>
            </a:lvl2pPr>
            <a:lvl3pPr marL="1111270" indent="0">
              <a:buNone/>
              <a:defRPr sz="1458"/>
            </a:lvl3pPr>
            <a:lvl4pPr marL="1666905" indent="0">
              <a:buNone/>
              <a:defRPr sz="1215"/>
            </a:lvl4pPr>
            <a:lvl5pPr marL="2222541" indent="0">
              <a:buNone/>
              <a:defRPr sz="1215"/>
            </a:lvl5pPr>
            <a:lvl6pPr marL="2778176" indent="0">
              <a:buNone/>
              <a:defRPr sz="1215"/>
            </a:lvl6pPr>
            <a:lvl7pPr marL="3333811" indent="0">
              <a:buNone/>
              <a:defRPr sz="1215"/>
            </a:lvl7pPr>
            <a:lvl8pPr marL="3889446" indent="0">
              <a:buNone/>
              <a:defRPr sz="1215"/>
            </a:lvl8pPr>
            <a:lvl9pPr marL="4445081" indent="0">
              <a:buNone/>
              <a:defRPr sz="121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6BC2C-ACBC-4160-801B-9E12759999D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1BC12-CD82-486C-8CA3-6C40BA0C40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9154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5432" y="935990"/>
            <a:ext cx="3584070" cy="3275965"/>
          </a:xfrm>
        </p:spPr>
        <p:txBody>
          <a:bodyPr anchor="b"/>
          <a:lstStyle>
            <a:lvl1pPr>
              <a:defRPr sz="388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724260" y="2021482"/>
            <a:ext cx="5625703" cy="9977393"/>
          </a:xfrm>
        </p:spPr>
        <p:txBody>
          <a:bodyPr anchor="t"/>
          <a:lstStyle>
            <a:lvl1pPr marL="0" indent="0">
              <a:buNone/>
              <a:defRPr sz="3889"/>
            </a:lvl1pPr>
            <a:lvl2pPr marL="555635" indent="0">
              <a:buNone/>
              <a:defRPr sz="3403"/>
            </a:lvl2pPr>
            <a:lvl3pPr marL="1111270" indent="0">
              <a:buNone/>
              <a:defRPr sz="2917"/>
            </a:lvl3pPr>
            <a:lvl4pPr marL="1666905" indent="0">
              <a:buNone/>
              <a:defRPr sz="2431"/>
            </a:lvl4pPr>
            <a:lvl5pPr marL="2222541" indent="0">
              <a:buNone/>
              <a:defRPr sz="2431"/>
            </a:lvl5pPr>
            <a:lvl6pPr marL="2778176" indent="0">
              <a:buNone/>
              <a:defRPr sz="2431"/>
            </a:lvl6pPr>
            <a:lvl7pPr marL="3333811" indent="0">
              <a:buNone/>
              <a:defRPr sz="2431"/>
            </a:lvl7pPr>
            <a:lvl8pPr marL="3889446" indent="0">
              <a:buNone/>
              <a:defRPr sz="2431"/>
            </a:lvl8pPr>
            <a:lvl9pPr marL="4445081" indent="0">
              <a:buNone/>
              <a:defRPr sz="2431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65432" y="4211955"/>
            <a:ext cx="3584070" cy="7803168"/>
          </a:xfrm>
        </p:spPr>
        <p:txBody>
          <a:bodyPr/>
          <a:lstStyle>
            <a:lvl1pPr marL="0" indent="0">
              <a:buNone/>
              <a:defRPr sz="1944"/>
            </a:lvl1pPr>
            <a:lvl2pPr marL="555635" indent="0">
              <a:buNone/>
              <a:defRPr sz="1701"/>
            </a:lvl2pPr>
            <a:lvl3pPr marL="1111270" indent="0">
              <a:buNone/>
              <a:defRPr sz="1458"/>
            </a:lvl3pPr>
            <a:lvl4pPr marL="1666905" indent="0">
              <a:buNone/>
              <a:defRPr sz="1215"/>
            </a:lvl4pPr>
            <a:lvl5pPr marL="2222541" indent="0">
              <a:buNone/>
              <a:defRPr sz="1215"/>
            </a:lvl5pPr>
            <a:lvl6pPr marL="2778176" indent="0">
              <a:buNone/>
              <a:defRPr sz="1215"/>
            </a:lvl6pPr>
            <a:lvl7pPr marL="3333811" indent="0">
              <a:buNone/>
              <a:defRPr sz="1215"/>
            </a:lvl7pPr>
            <a:lvl8pPr marL="3889446" indent="0">
              <a:buNone/>
              <a:defRPr sz="1215"/>
            </a:lvl8pPr>
            <a:lvl9pPr marL="4445081" indent="0">
              <a:buNone/>
              <a:defRPr sz="1215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6BC2C-ACBC-4160-801B-9E12759999D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C1BC12-CD82-486C-8CA3-6C40BA0C40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21926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63985" y="747495"/>
            <a:ext cx="9584531" cy="271372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3985" y="3737460"/>
            <a:ext cx="9584531" cy="89081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63984" y="13012864"/>
            <a:ext cx="2500313" cy="747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C6BC2C-ACBC-4160-801B-9E12759999D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81016" y="13012864"/>
            <a:ext cx="3750469" cy="747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848203" y="13012864"/>
            <a:ext cx="2500313" cy="747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5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C1BC12-CD82-486C-8CA3-6C40BA0C409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142399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111270" rtl="0" eaLnBrk="1" latinLnBrk="0" hangingPunct="1">
        <a:lnSpc>
          <a:spcPct val="90000"/>
        </a:lnSpc>
        <a:spcBef>
          <a:spcPct val="0"/>
        </a:spcBef>
        <a:buNone/>
        <a:defRPr sz="534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7818" indent="-277818" algn="l" defTabSz="1111270" rtl="0" eaLnBrk="1" latinLnBrk="0" hangingPunct="1">
        <a:lnSpc>
          <a:spcPct val="90000"/>
        </a:lnSpc>
        <a:spcBef>
          <a:spcPts val="1215"/>
        </a:spcBef>
        <a:buFont typeface="Arial" panose="020B0604020202020204" pitchFamily="34" charset="0"/>
        <a:buChar char="•"/>
        <a:defRPr sz="3403" kern="1200">
          <a:solidFill>
            <a:schemeClr val="tx1"/>
          </a:solidFill>
          <a:latin typeface="+mn-lt"/>
          <a:ea typeface="+mn-ea"/>
          <a:cs typeface="+mn-cs"/>
        </a:defRPr>
      </a:lvl1pPr>
      <a:lvl2pPr marL="833453" indent="-277818" algn="l" defTabSz="1111270" rtl="0" eaLnBrk="1" latinLnBrk="0" hangingPunct="1">
        <a:lnSpc>
          <a:spcPct val="90000"/>
        </a:lnSpc>
        <a:spcBef>
          <a:spcPts val="608"/>
        </a:spcBef>
        <a:buFont typeface="Arial" panose="020B0604020202020204" pitchFamily="34" charset="0"/>
        <a:buChar char="•"/>
        <a:defRPr sz="2917" kern="1200">
          <a:solidFill>
            <a:schemeClr val="tx1"/>
          </a:solidFill>
          <a:latin typeface="+mn-lt"/>
          <a:ea typeface="+mn-ea"/>
          <a:cs typeface="+mn-cs"/>
        </a:defRPr>
      </a:lvl2pPr>
      <a:lvl3pPr marL="1389088" indent="-277818" algn="l" defTabSz="1111270" rtl="0" eaLnBrk="1" latinLnBrk="0" hangingPunct="1">
        <a:lnSpc>
          <a:spcPct val="90000"/>
        </a:lnSpc>
        <a:spcBef>
          <a:spcPts val="608"/>
        </a:spcBef>
        <a:buFont typeface="Arial" panose="020B0604020202020204" pitchFamily="34" charset="0"/>
        <a:buChar char="•"/>
        <a:defRPr sz="2431" kern="1200">
          <a:solidFill>
            <a:schemeClr val="tx1"/>
          </a:solidFill>
          <a:latin typeface="+mn-lt"/>
          <a:ea typeface="+mn-ea"/>
          <a:cs typeface="+mn-cs"/>
        </a:defRPr>
      </a:lvl3pPr>
      <a:lvl4pPr marL="1944723" indent="-277818" algn="l" defTabSz="1111270" rtl="0" eaLnBrk="1" latinLnBrk="0" hangingPunct="1">
        <a:lnSpc>
          <a:spcPct val="90000"/>
        </a:lnSpc>
        <a:spcBef>
          <a:spcPts val="608"/>
        </a:spcBef>
        <a:buFont typeface="Arial" panose="020B0604020202020204" pitchFamily="34" charset="0"/>
        <a:buChar char="•"/>
        <a:defRPr sz="2188" kern="1200">
          <a:solidFill>
            <a:schemeClr val="tx1"/>
          </a:solidFill>
          <a:latin typeface="+mn-lt"/>
          <a:ea typeface="+mn-ea"/>
          <a:cs typeface="+mn-cs"/>
        </a:defRPr>
      </a:lvl4pPr>
      <a:lvl5pPr marL="2500358" indent="-277818" algn="l" defTabSz="1111270" rtl="0" eaLnBrk="1" latinLnBrk="0" hangingPunct="1">
        <a:lnSpc>
          <a:spcPct val="90000"/>
        </a:lnSpc>
        <a:spcBef>
          <a:spcPts val="608"/>
        </a:spcBef>
        <a:buFont typeface="Arial" panose="020B0604020202020204" pitchFamily="34" charset="0"/>
        <a:buChar char="•"/>
        <a:defRPr sz="2188" kern="1200">
          <a:solidFill>
            <a:schemeClr val="tx1"/>
          </a:solidFill>
          <a:latin typeface="+mn-lt"/>
          <a:ea typeface="+mn-ea"/>
          <a:cs typeface="+mn-cs"/>
        </a:defRPr>
      </a:lvl5pPr>
      <a:lvl6pPr marL="3055993" indent="-277818" algn="l" defTabSz="1111270" rtl="0" eaLnBrk="1" latinLnBrk="0" hangingPunct="1">
        <a:lnSpc>
          <a:spcPct val="90000"/>
        </a:lnSpc>
        <a:spcBef>
          <a:spcPts val="608"/>
        </a:spcBef>
        <a:buFont typeface="Arial" panose="020B0604020202020204" pitchFamily="34" charset="0"/>
        <a:buChar char="•"/>
        <a:defRPr sz="2188" kern="1200">
          <a:solidFill>
            <a:schemeClr val="tx1"/>
          </a:solidFill>
          <a:latin typeface="+mn-lt"/>
          <a:ea typeface="+mn-ea"/>
          <a:cs typeface="+mn-cs"/>
        </a:defRPr>
      </a:lvl6pPr>
      <a:lvl7pPr marL="3611629" indent="-277818" algn="l" defTabSz="1111270" rtl="0" eaLnBrk="1" latinLnBrk="0" hangingPunct="1">
        <a:lnSpc>
          <a:spcPct val="90000"/>
        </a:lnSpc>
        <a:spcBef>
          <a:spcPts val="608"/>
        </a:spcBef>
        <a:buFont typeface="Arial" panose="020B0604020202020204" pitchFamily="34" charset="0"/>
        <a:buChar char="•"/>
        <a:defRPr sz="2188" kern="1200">
          <a:solidFill>
            <a:schemeClr val="tx1"/>
          </a:solidFill>
          <a:latin typeface="+mn-lt"/>
          <a:ea typeface="+mn-ea"/>
          <a:cs typeface="+mn-cs"/>
        </a:defRPr>
      </a:lvl7pPr>
      <a:lvl8pPr marL="4167264" indent="-277818" algn="l" defTabSz="1111270" rtl="0" eaLnBrk="1" latinLnBrk="0" hangingPunct="1">
        <a:lnSpc>
          <a:spcPct val="90000"/>
        </a:lnSpc>
        <a:spcBef>
          <a:spcPts val="608"/>
        </a:spcBef>
        <a:buFont typeface="Arial" panose="020B0604020202020204" pitchFamily="34" charset="0"/>
        <a:buChar char="•"/>
        <a:defRPr sz="2188" kern="1200">
          <a:solidFill>
            <a:schemeClr val="tx1"/>
          </a:solidFill>
          <a:latin typeface="+mn-lt"/>
          <a:ea typeface="+mn-ea"/>
          <a:cs typeface="+mn-cs"/>
        </a:defRPr>
      </a:lvl8pPr>
      <a:lvl9pPr marL="4722899" indent="-277818" algn="l" defTabSz="1111270" rtl="0" eaLnBrk="1" latinLnBrk="0" hangingPunct="1">
        <a:lnSpc>
          <a:spcPct val="90000"/>
        </a:lnSpc>
        <a:spcBef>
          <a:spcPts val="608"/>
        </a:spcBef>
        <a:buFont typeface="Arial" panose="020B0604020202020204" pitchFamily="34" charset="0"/>
        <a:buChar char="•"/>
        <a:defRPr sz="21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11270" rtl="0" eaLnBrk="1" latinLnBrk="0" hangingPunct="1">
        <a:defRPr sz="2188" kern="1200">
          <a:solidFill>
            <a:schemeClr val="tx1"/>
          </a:solidFill>
          <a:latin typeface="+mn-lt"/>
          <a:ea typeface="+mn-ea"/>
          <a:cs typeface="+mn-cs"/>
        </a:defRPr>
      </a:lvl1pPr>
      <a:lvl2pPr marL="555635" algn="l" defTabSz="1111270" rtl="0" eaLnBrk="1" latinLnBrk="0" hangingPunct="1">
        <a:defRPr sz="2188" kern="1200">
          <a:solidFill>
            <a:schemeClr val="tx1"/>
          </a:solidFill>
          <a:latin typeface="+mn-lt"/>
          <a:ea typeface="+mn-ea"/>
          <a:cs typeface="+mn-cs"/>
        </a:defRPr>
      </a:lvl2pPr>
      <a:lvl3pPr marL="1111270" algn="l" defTabSz="1111270" rtl="0" eaLnBrk="1" latinLnBrk="0" hangingPunct="1">
        <a:defRPr sz="2188" kern="1200">
          <a:solidFill>
            <a:schemeClr val="tx1"/>
          </a:solidFill>
          <a:latin typeface="+mn-lt"/>
          <a:ea typeface="+mn-ea"/>
          <a:cs typeface="+mn-cs"/>
        </a:defRPr>
      </a:lvl3pPr>
      <a:lvl4pPr marL="1666905" algn="l" defTabSz="1111270" rtl="0" eaLnBrk="1" latinLnBrk="0" hangingPunct="1">
        <a:defRPr sz="2188" kern="1200">
          <a:solidFill>
            <a:schemeClr val="tx1"/>
          </a:solidFill>
          <a:latin typeface="+mn-lt"/>
          <a:ea typeface="+mn-ea"/>
          <a:cs typeface="+mn-cs"/>
        </a:defRPr>
      </a:lvl4pPr>
      <a:lvl5pPr marL="2222541" algn="l" defTabSz="1111270" rtl="0" eaLnBrk="1" latinLnBrk="0" hangingPunct="1">
        <a:defRPr sz="2188" kern="1200">
          <a:solidFill>
            <a:schemeClr val="tx1"/>
          </a:solidFill>
          <a:latin typeface="+mn-lt"/>
          <a:ea typeface="+mn-ea"/>
          <a:cs typeface="+mn-cs"/>
        </a:defRPr>
      </a:lvl5pPr>
      <a:lvl6pPr marL="2778176" algn="l" defTabSz="1111270" rtl="0" eaLnBrk="1" latinLnBrk="0" hangingPunct="1">
        <a:defRPr sz="2188" kern="1200">
          <a:solidFill>
            <a:schemeClr val="tx1"/>
          </a:solidFill>
          <a:latin typeface="+mn-lt"/>
          <a:ea typeface="+mn-ea"/>
          <a:cs typeface="+mn-cs"/>
        </a:defRPr>
      </a:lvl6pPr>
      <a:lvl7pPr marL="3333811" algn="l" defTabSz="1111270" rtl="0" eaLnBrk="1" latinLnBrk="0" hangingPunct="1">
        <a:defRPr sz="2188" kern="1200">
          <a:solidFill>
            <a:schemeClr val="tx1"/>
          </a:solidFill>
          <a:latin typeface="+mn-lt"/>
          <a:ea typeface="+mn-ea"/>
          <a:cs typeface="+mn-cs"/>
        </a:defRPr>
      </a:lvl7pPr>
      <a:lvl8pPr marL="3889446" algn="l" defTabSz="1111270" rtl="0" eaLnBrk="1" latinLnBrk="0" hangingPunct="1">
        <a:defRPr sz="2188" kern="1200">
          <a:solidFill>
            <a:schemeClr val="tx1"/>
          </a:solidFill>
          <a:latin typeface="+mn-lt"/>
          <a:ea typeface="+mn-ea"/>
          <a:cs typeface="+mn-cs"/>
        </a:defRPr>
      </a:lvl8pPr>
      <a:lvl9pPr marL="4445081" algn="l" defTabSz="1111270" rtl="0" eaLnBrk="1" latinLnBrk="0" hangingPunct="1">
        <a:defRPr sz="21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13" Type="http://schemas.openxmlformats.org/officeDocument/2006/relationships/chart" Target="../charts/chart6.xml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12" Type="http://schemas.openxmlformats.org/officeDocument/2006/relationships/chart" Target="../charts/chart5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11" Type="http://schemas.openxmlformats.org/officeDocument/2006/relationships/chart" Target="../charts/chart4.xml"/><Relationship Id="rId5" Type="http://schemas.openxmlformats.org/officeDocument/2006/relationships/image" Target="../media/image4.jpeg"/><Relationship Id="rId10" Type="http://schemas.openxmlformats.org/officeDocument/2006/relationships/chart" Target="../charts/chart3.xml"/><Relationship Id="rId4" Type="http://schemas.openxmlformats.org/officeDocument/2006/relationships/image" Target="../media/image3.jpeg"/><Relationship Id="rId9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组合 3">
            <a:extLst>
              <a:ext uri="{FF2B5EF4-FFF2-40B4-BE49-F238E27FC236}">
                <a16:creationId xmlns:a16="http://schemas.microsoft.com/office/drawing/2014/main" id="{6F116728-BF25-44DC-BE80-E702BAC0B9C4}"/>
              </a:ext>
            </a:extLst>
          </p:cNvPr>
          <p:cNvGrpSpPr/>
          <p:nvPr/>
        </p:nvGrpSpPr>
        <p:grpSpPr>
          <a:xfrm>
            <a:off x="-454064" y="216081"/>
            <a:ext cx="11192403" cy="12819980"/>
            <a:chOff x="-246185" y="61281"/>
            <a:chExt cx="10662090" cy="12699927"/>
          </a:xfrm>
        </p:grpSpPr>
        <p:sp>
          <p:nvSpPr>
            <p:cNvPr id="37" name="文本框 199">
              <a:extLst>
                <a:ext uri="{FF2B5EF4-FFF2-40B4-BE49-F238E27FC236}">
                  <a16:creationId xmlns:a16="http://schemas.microsoft.com/office/drawing/2014/main" id="{1709D05A-5D27-4BC5-9F4E-87C532040D3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435423" y="630794"/>
              <a:ext cx="7421563" cy="5873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77528" tIns="38764" rIns="77528" bIns="38764" numCol="1" anchor="t" anchorCtr="0" compatLnSpc="1">
              <a:prstTxWarp prst="textNoShape">
                <a:avLst/>
              </a:prstTxWarp>
            </a:bodyPr>
            <a:lstStyle>
              <a:lvl1pPr indent="3048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indent="258440" defTabSz="775320"/>
              <a:r>
                <a:rPr lang="en-US" altLang="zh-CN" sz="1017" b="1" dirty="0">
                  <a:ea typeface="Times New Roman" panose="02020603050405020304" pitchFamily="18" charset="0"/>
                  <a:cs typeface="Times New Roman" panose="02020603050405020304" pitchFamily="18" charset="0"/>
                </a:rPr>
                <a:t>GY/MG                                                       YO/MG                                                        RE/MG</a:t>
              </a:r>
              <a:endParaRPr lang="en-US" altLang="zh-CN" sz="678" b="1" dirty="0"/>
            </a:p>
            <a:p>
              <a:pPr indent="258440" defTabSz="775320"/>
              <a:r>
                <a:rPr lang="en-US" altLang="zh-CN" sz="1526" b="1" dirty="0"/>
                <a:t> </a:t>
              </a:r>
            </a:p>
          </p:txBody>
        </p:sp>
        <p:grpSp>
          <p:nvGrpSpPr>
            <p:cNvPr id="38" name="组合 37">
              <a:extLst>
                <a:ext uri="{FF2B5EF4-FFF2-40B4-BE49-F238E27FC236}">
                  <a16:creationId xmlns:a16="http://schemas.microsoft.com/office/drawing/2014/main" id="{20598393-F036-4AE4-969A-119738867D99}"/>
                </a:ext>
              </a:extLst>
            </p:cNvPr>
            <p:cNvGrpSpPr/>
            <p:nvPr/>
          </p:nvGrpSpPr>
          <p:grpSpPr>
            <a:xfrm>
              <a:off x="4191000" y="1076325"/>
              <a:ext cx="3173730" cy="6201410"/>
              <a:chOff x="526468" y="-32283"/>
              <a:chExt cx="3174544" cy="6201505"/>
            </a:xfrm>
          </p:grpSpPr>
          <p:grpSp>
            <p:nvGrpSpPr>
              <p:cNvPr id="39" name="组合 38">
                <a:extLst>
                  <a:ext uri="{FF2B5EF4-FFF2-40B4-BE49-F238E27FC236}">
                    <a16:creationId xmlns:a16="http://schemas.microsoft.com/office/drawing/2014/main" id="{BD7C445F-E8D6-46E7-AAD7-8164AD766956}"/>
                  </a:ext>
                </a:extLst>
              </p:cNvPr>
              <p:cNvGrpSpPr/>
              <p:nvPr/>
            </p:nvGrpSpPr>
            <p:grpSpPr>
              <a:xfrm>
                <a:off x="526468" y="2966925"/>
                <a:ext cx="3174544" cy="3202297"/>
                <a:chOff x="526468" y="36689"/>
                <a:chExt cx="3174544" cy="3202297"/>
              </a:xfrm>
            </p:grpSpPr>
            <p:sp>
              <p:nvSpPr>
                <p:cNvPr id="43" name="文本框 319">
                  <a:extLst>
                    <a:ext uri="{FF2B5EF4-FFF2-40B4-BE49-F238E27FC236}">
                      <a16:creationId xmlns:a16="http://schemas.microsoft.com/office/drawing/2014/main" id="{DECBFC04-1C08-4F6F-9BB2-BD0807F364A7}"/>
                    </a:ext>
                  </a:extLst>
                </p:cNvPr>
                <p:cNvSpPr txBox="1"/>
                <p:nvPr/>
              </p:nvSpPr>
              <p:spPr>
                <a:xfrm>
                  <a:off x="526468" y="132645"/>
                  <a:ext cx="2842493" cy="3106341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Metabolic pathway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Biosynthesis of secondary metabolite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henylpropan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arbon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lant hormone signal transduction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yrimidine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urine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RNA polymerase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Flavon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yanoamino acid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ircadian rhythm − plant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Galactose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entose and glucuronate interconversion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orphyrin and chlorophyll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Other glycan degradation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Sphingolipid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Stilbenoid, diarylheptanoid and gingerol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utin, suberine and wax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henylalanine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Diterpen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Ster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Glycosaminoglycan degradation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Glycosphingolipid biosynthesis − ganglio serie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Indole alkal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Tropane, piperidine and pyridine alkal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Linoleic acid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Sesquiterpenoid and triterpen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Isoflavon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Thiamine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Flavone and flavonol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 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44" name="图片 43">
                  <a:extLst>
                    <a:ext uri="{FF2B5EF4-FFF2-40B4-BE49-F238E27FC236}">
                      <a16:creationId xmlns:a16="http://schemas.microsoft.com/office/drawing/2014/main" id="{8215328B-1BB7-4D0C-BF2F-AD71FEA77C4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926" t="5980" r="9324" b="52610"/>
                <a:stretch/>
              </p:blipFill>
              <p:spPr bwMode="auto">
                <a:xfrm rot="5400000">
                  <a:off x="1308567" y="623900"/>
                  <a:ext cx="2979656" cy="180523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</p:grpSp>
          <p:grpSp>
            <p:nvGrpSpPr>
              <p:cNvPr id="40" name="组合 39">
                <a:extLst>
                  <a:ext uri="{FF2B5EF4-FFF2-40B4-BE49-F238E27FC236}">
                    <a16:creationId xmlns:a16="http://schemas.microsoft.com/office/drawing/2014/main" id="{4CCF851A-81DE-4533-A864-E265A9FAED61}"/>
                  </a:ext>
                </a:extLst>
              </p:cNvPr>
              <p:cNvGrpSpPr/>
              <p:nvPr/>
            </p:nvGrpSpPr>
            <p:grpSpPr>
              <a:xfrm>
                <a:off x="526473" y="-32283"/>
                <a:ext cx="3174539" cy="3031790"/>
                <a:chOff x="491836" y="-32264"/>
                <a:chExt cx="3174539" cy="3031790"/>
              </a:xfrm>
            </p:grpSpPr>
            <p:sp>
              <p:nvSpPr>
                <p:cNvPr id="41" name="文本框 418">
                  <a:extLst>
                    <a:ext uri="{FF2B5EF4-FFF2-40B4-BE49-F238E27FC236}">
                      <a16:creationId xmlns:a16="http://schemas.microsoft.com/office/drawing/2014/main" id="{A46C3B64-A511-4C97-82C2-77DBF3F54550}"/>
                    </a:ext>
                  </a:extLst>
                </p:cNvPr>
                <p:cNvSpPr txBox="1"/>
                <p:nvPr/>
              </p:nvSpPr>
              <p:spPr>
                <a:xfrm>
                  <a:off x="491836" y="80265"/>
                  <a:ext cx="2406806" cy="2919261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Metabolic pathway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Biosynthesis of secondary metabolite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henylpropan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arbon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lant hormone signal transduction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yrimidine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urine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RNA polymerase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Flavon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yanoamino acid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ircadian rhythm − plant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Galactose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entose and glucuronate interconversion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orphyrin and chlorophyll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Other glycan degradation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Sphingolipid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Stilbenoid, diarylheptanoid and gingerol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utin, suberine and wax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henylalanine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Diterpen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Ster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Glycosaminoglycan degradation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Glycosphingolipid biosynthesis − ganglio serie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Indole alkal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Tropane, piperidine and pyridine alkal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Linoleic acid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Sesquiterpenoid and triterpen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Isoflavon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Thiamine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Flavone and flavonol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42" name="图片 41">
                  <a:extLst>
                    <a:ext uri="{FF2B5EF4-FFF2-40B4-BE49-F238E27FC236}">
                      <a16:creationId xmlns:a16="http://schemas.microsoft.com/office/drawing/2014/main" id="{DCD1B7E0-297C-481D-8B0A-E0E717E0B38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121" t="5244" r="6993" b="53165"/>
                <a:stretch/>
              </p:blipFill>
              <p:spPr bwMode="auto">
                <a:xfrm rot="5400000">
                  <a:off x="1295869" y="596437"/>
                  <a:ext cx="2999208" cy="174180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</p:grpSp>
        </p:grpSp>
        <p:grpSp>
          <p:nvGrpSpPr>
            <p:cNvPr id="45" name="组合 44">
              <a:extLst>
                <a:ext uri="{FF2B5EF4-FFF2-40B4-BE49-F238E27FC236}">
                  <a16:creationId xmlns:a16="http://schemas.microsoft.com/office/drawing/2014/main" id="{930F54C1-ACA5-4217-843B-2AA6962FCE99}"/>
                </a:ext>
              </a:extLst>
            </p:cNvPr>
            <p:cNvGrpSpPr/>
            <p:nvPr/>
          </p:nvGrpSpPr>
          <p:grpSpPr>
            <a:xfrm>
              <a:off x="668020" y="1073785"/>
              <a:ext cx="3566160" cy="5913755"/>
              <a:chOff x="-52388" y="0"/>
              <a:chExt cx="3566495" cy="5914341"/>
            </a:xfrm>
          </p:grpSpPr>
          <p:grpSp>
            <p:nvGrpSpPr>
              <p:cNvPr id="46" name="组合 45">
                <a:extLst>
                  <a:ext uri="{FF2B5EF4-FFF2-40B4-BE49-F238E27FC236}">
                    <a16:creationId xmlns:a16="http://schemas.microsoft.com/office/drawing/2014/main" id="{3F592533-5DB5-439E-BCB1-789746334DA1}"/>
                  </a:ext>
                </a:extLst>
              </p:cNvPr>
              <p:cNvGrpSpPr/>
              <p:nvPr/>
            </p:nvGrpSpPr>
            <p:grpSpPr>
              <a:xfrm>
                <a:off x="-52388" y="0"/>
                <a:ext cx="3445021" cy="5914341"/>
                <a:chOff x="-52388" y="0"/>
                <a:chExt cx="3445021" cy="5914341"/>
              </a:xfrm>
            </p:grpSpPr>
            <p:sp>
              <p:nvSpPr>
                <p:cNvPr id="48" name="文本框 298">
                  <a:extLst>
                    <a:ext uri="{FF2B5EF4-FFF2-40B4-BE49-F238E27FC236}">
                      <a16:creationId xmlns:a16="http://schemas.microsoft.com/office/drawing/2014/main" id="{CA238D16-0048-4BAA-911A-7282759F5A03}"/>
                    </a:ext>
                  </a:extLst>
                </p:cNvPr>
                <p:cNvSpPr txBox="1"/>
                <p:nvPr/>
              </p:nvSpPr>
              <p:spPr>
                <a:xfrm>
                  <a:off x="-52388" y="103611"/>
                  <a:ext cx="2354252" cy="2819137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Flavon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arbon fixation in photosynthetic organism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ircadian rhythm </a:t>
                  </a:r>
                  <a:r>
                    <a:rPr lang="en-US" sz="678" kern="100"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rPr>
                    <a:t>−</a:t>
                  </a: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 plant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Arginine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Tyrosine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henylalanine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Terpenoid backbone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orphyrin and chlorophyll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Isoquinoline alkal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Sphingolipid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Stilbenoid, diarylheptanoid and gingerol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henylalanine, tyrosine and tryptophan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Tropane, piperidine and pyridine alkal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aroten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Sulfur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Diterpen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hot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utin, suberine and wax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Indole alkal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Sesquiterpenoid and triterpen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hotosynthesis </a:t>
                  </a:r>
                  <a:r>
                    <a:rPr lang="en-US" sz="678" kern="100"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rPr>
                    <a:t>−</a:t>
                  </a: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 antenna protein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Flavone and flavonol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 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49" name="图片 48">
                  <a:extLst>
                    <a:ext uri="{FF2B5EF4-FFF2-40B4-BE49-F238E27FC236}">
                      <a16:creationId xmlns:a16="http://schemas.microsoft.com/office/drawing/2014/main" id="{FE7267A7-91B5-4569-BFB5-B1C7ADAB0A1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037" t="5263" r="9404" b="52491"/>
                <a:stretch/>
              </p:blipFill>
              <p:spPr bwMode="auto">
                <a:xfrm rot="5400000">
                  <a:off x="1014240" y="501333"/>
                  <a:ext cx="2879725" cy="187706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sp>
              <p:nvSpPr>
                <p:cNvPr id="50" name="文本框 300">
                  <a:extLst>
                    <a:ext uri="{FF2B5EF4-FFF2-40B4-BE49-F238E27FC236}">
                      <a16:creationId xmlns:a16="http://schemas.microsoft.com/office/drawing/2014/main" id="{D8C82EB3-3115-462E-9A0B-26DF04927703}"/>
                    </a:ext>
                  </a:extLst>
                </p:cNvPr>
                <p:cNvSpPr txBox="1"/>
                <p:nvPr/>
              </p:nvSpPr>
              <p:spPr>
                <a:xfrm>
                  <a:off x="0" y="3095204"/>
                  <a:ext cx="2301875" cy="2819137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Flavonoid biosynthesis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arbon fixation in photosynthetic organisms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ircadian rhythm </a:t>
                  </a:r>
                  <a:r>
                    <a:rPr lang="en-US" sz="678" kern="100" dirty="0"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rPr>
                    <a:t>−</a:t>
                  </a: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 plant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Arginine biosynthesis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Tyrosine metabolism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henylalanine metabolism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Terpenoid backbone biosynthesis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orphyrin and chlorophyll metabolism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 err="1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Isoquinoline</a:t>
                  </a: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 alkaloid biosynthesis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Sphingolipid metabolism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 err="1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Stilbenoid</a:t>
                  </a: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, diarylheptanoid and gingerol biosynthesis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henylalanine, tyrosine and tryptophan biosynthesis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Tropane, piperidine and pyridine alkaloid biosynthesis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arotenoid biosynthesis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Sulfur metabolism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Diterpenoid biosynthesis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hotosynthesis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 err="1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utin</a:t>
                  </a: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, </a:t>
                  </a:r>
                  <a:r>
                    <a:rPr lang="en-US" sz="678" kern="100" dirty="0" err="1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suberine</a:t>
                  </a: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 and wax biosynthesis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Indole alkaloid biosynthesis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Sesquiterpenoid and triterpenoid biosynthesis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hotosynthesis </a:t>
                  </a:r>
                  <a:r>
                    <a:rPr lang="en-US" sz="678" kern="100" dirty="0">
                      <a:latin typeface="Times New Roman" panose="02020603050405020304" pitchFamily="18" charset="0"/>
                      <a:ea typeface="微软雅黑" panose="020B0503020204020204" pitchFamily="34" charset="-122"/>
                      <a:cs typeface="Times New Roman" panose="02020603050405020304" pitchFamily="18" charset="0"/>
                    </a:rPr>
                    <a:t>−</a:t>
                  </a: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 antenna proteins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Flavone and </a:t>
                  </a:r>
                  <a:r>
                    <a:rPr lang="en-US" sz="678" kern="100" dirty="0" err="1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flavonol</a:t>
                  </a: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 biosynthesis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7683">
                    <a:lnSpc>
                      <a:spcPts val="848"/>
                    </a:lnSpc>
                  </a:pPr>
                  <a:r>
                    <a:rPr lang="en-US" sz="678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 </a:t>
                  </a:r>
                  <a:endParaRPr lang="zh-CN" altLang="en-US" sz="1017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47" name="图片 46">
                <a:extLst>
                  <a:ext uri="{FF2B5EF4-FFF2-40B4-BE49-F238E27FC236}">
                    <a16:creationId xmlns:a16="http://schemas.microsoft.com/office/drawing/2014/main" id="{2DC7A158-B404-4FFC-8826-590769EF6DB2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96" t="5492" r="9354" b="53179"/>
              <a:stretch/>
            </p:blipFill>
            <p:spPr bwMode="auto">
              <a:xfrm rot="5400000">
                <a:off x="1082374" y="3452595"/>
                <a:ext cx="2864485" cy="1998980"/>
              </a:xfrm>
              <a:prstGeom prst="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</p:grpSp>
        <p:grpSp>
          <p:nvGrpSpPr>
            <p:cNvPr id="51" name="组合 50">
              <a:extLst>
                <a:ext uri="{FF2B5EF4-FFF2-40B4-BE49-F238E27FC236}">
                  <a16:creationId xmlns:a16="http://schemas.microsoft.com/office/drawing/2014/main" id="{252B769C-1FB5-484F-90DC-69CC0226357F}"/>
                </a:ext>
              </a:extLst>
            </p:cNvPr>
            <p:cNvGrpSpPr/>
            <p:nvPr/>
          </p:nvGrpSpPr>
          <p:grpSpPr>
            <a:xfrm>
              <a:off x="7235825" y="1074420"/>
              <a:ext cx="3180080" cy="6047740"/>
              <a:chOff x="-118546" y="-67"/>
              <a:chExt cx="3180350" cy="6048509"/>
            </a:xfrm>
          </p:grpSpPr>
          <p:grpSp>
            <p:nvGrpSpPr>
              <p:cNvPr id="52" name="组合 51">
                <a:extLst>
                  <a:ext uri="{FF2B5EF4-FFF2-40B4-BE49-F238E27FC236}">
                    <a16:creationId xmlns:a16="http://schemas.microsoft.com/office/drawing/2014/main" id="{62C20557-A46C-412E-ABE9-3F6778F75378}"/>
                  </a:ext>
                </a:extLst>
              </p:cNvPr>
              <p:cNvGrpSpPr/>
              <p:nvPr/>
            </p:nvGrpSpPr>
            <p:grpSpPr>
              <a:xfrm>
                <a:off x="-118546" y="105819"/>
                <a:ext cx="3180272" cy="5942623"/>
                <a:chOff x="-83927" y="106548"/>
                <a:chExt cx="3180729" cy="5942673"/>
              </a:xfrm>
            </p:grpSpPr>
            <p:grpSp>
              <p:nvGrpSpPr>
                <p:cNvPr id="54" name="组合 53">
                  <a:extLst>
                    <a:ext uri="{FF2B5EF4-FFF2-40B4-BE49-F238E27FC236}">
                      <a16:creationId xmlns:a16="http://schemas.microsoft.com/office/drawing/2014/main" id="{0B51A485-ADFC-4B27-A9FA-E7184BE3F81E}"/>
                    </a:ext>
                  </a:extLst>
                </p:cNvPr>
                <p:cNvGrpSpPr/>
                <p:nvPr/>
              </p:nvGrpSpPr>
              <p:grpSpPr>
                <a:xfrm>
                  <a:off x="-83917" y="2974249"/>
                  <a:ext cx="3180719" cy="3074972"/>
                  <a:chOff x="-83917" y="-18101"/>
                  <a:chExt cx="3180719" cy="3038402"/>
                </a:xfrm>
              </p:grpSpPr>
              <p:sp>
                <p:nvSpPr>
                  <p:cNvPr id="56" name="文本框 313">
                    <a:extLst>
                      <a:ext uri="{FF2B5EF4-FFF2-40B4-BE49-F238E27FC236}">
                        <a16:creationId xmlns:a16="http://schemas.microsoft.com/office/drawing/2014/main" id="{3FC1B1F1-DCB1-4A4C-AE80-122C69BA2159}"/>
                      </a:ext>
                    </a:extLst>
                  </p:cNvPr>
                  <p:cNvSpPr txBox="1"/>
                  <p:nvPr/>
                </p:nvSpPr>
                <p:spPr>
                  <a:xfrm>
                    <a:off x="-83917" y="34583"/>
                    <a:ext cx="2425492" cy="2985718"/>
                  </a:xfrm>
                  <a:prstGeom prst="rect">
                    <a:avLst/>
                  </a:prstGeom>
                  <a:noFill/>
                  <a:ln w="6350">
                    <a:noFill/>
                  </a:ln>
                </p:spPr>
                <p:txBody>
                  <a:bodyPr rot="0" spcFirstLastPara="0" vert="horz" wrap="square" lIns="0" tIns="0" rIns="0" bIns="0" numCol="1" spcCol="0" rtlCol="0" fromWordArt="0" anchor="t" anchorCtr="0" forceAA="0" compatLnSpc="1">
                    <a:prstTxWarp prst="textNoShape">
                      <a:avLst/>
                    </a:prstTxWarp>
                    <a:noAutofit/>
                  </a:bodyPr>
                  <a:lstStyle/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Metabolic pathways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Biosynthesis of secondary metabolites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Plant hormone signal transduction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Biosynthesis of amino acids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Carbon metabolism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Phenylpropanoid biosynthesis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MAPK signaling pathway − plant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Cysteine and methionine metabolism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Glycerolipid metabolism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Cyanoamino acid metabolism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Peroxisome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Galactose metabolism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Pentose and glucuronate interconversions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2−Oxocarboxylic acid metabolism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Circadian rhythm − plant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Flavonoid biosynthesis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Tyrosine metabolism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Fructose and mannose metabolism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Phenylalanine metabolism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Sphingolipid metabolism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Phenylalanine, tyrosine and tryptophan biosynthesis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Stilbenoid, diarylheptanoid and gingerol biosynthesis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Isoquinoline alkaloid biosynthesis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alpha−Linolenic acid metabolism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Tropane, piperidine and pyridine alkaloid biosynthesis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Cutin, suberine and wax biosynthesis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Glycosphingolipid biosynthesis − ganglio series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Indole alkaloid biosynthesis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Isoflavonoid biosynthesis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indent="106606">
                      <a:lnSpc>
                        <a:spcPts val="636"/>
                      </a:lnSpc>
                    </a:pPr>
                    <a:r>
                      <a:rPr lang="en-US" sz="678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Flavone and flavonol biosynthesis</a:t>
                    </a:r>
                    <a:endParaRPr lang="zh-CN" altLang="en-US" sz="1017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pic>
                <p:nvPicPr>
                  <p:cNvPr id="57" name="图片 56">
                    <a:extLst>
                      <a:ext uri="{FF2B5EF4-FFF2-40B4-BE49-F238E27FC236}">
                        <a16:creationId xmlns:a16="http://schemas.microsoft.com/office/drawing/2014/main" id="{BE9BEBDC-5C5B-498B-A3D9-6D59B0A7B08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834" t="6380" r="9391" b="52889"/>
                  <a:stretch/>
                </p:blipFill>
                <p:spPr bwMode="auto">
                  <a:xfrm rot="5400000">
                    <a:off x="810258" y="563318"/>
                    <a:ext cx="2867963" cy="170512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53640926-AAD7-44D8-BBD7-CCE9431645EC}">
                      <a14:shadowObscured xmlns:a14="http://schemas.microsoft.com/office/drawing/2010/main"/>
                    </a:ext>
                  </a:extLst>
                </p:spPr>
              </p:pic>
            </p:grpSp>
            <p:sp>
              <p:nvSpPr>
                <p:cNvPr id="55" name="文本框 315">
                  <a:extLst>
                    <a:ext uri="{FF2B5EF4-FFF2-40B4-BE49-F238E27FC236}">
                      <a16:creationId xmlns:a16="http://schemas.microsoft.com/office/drawing/2014/main" id="{C5A8773D-23D3-4D1D-9F5B-51DBA56A0B1A}"/>
                    </a:ext>
                  </a:extLst>
                </p:cNvPr>
                <p:cNvSpPr txBox="1"/>
                <p:nvPr/>
              </p:nvSpPr>
              <p:spPr>
                <a:xfrm>
                  <a:off x="-83927" y="106548"/>
                  <a:ext cx="2470817" cy="2867562"/>
                </a:xfrm>
                <a:prstGeom prst="rect">
                  <a:avLst/>
                </a:prstGeom>
                <a:noFill/>
                <a:ln w="6350">
                  <a:noFill/>
                </a:ln>
              </p:spPr>
              <p:txBody>
                <a:bodyPr rot="0" spcFirstLastPara="0" vert="horz" wrap="square" lIns="0" tIns="0" rIns="0" bIns="0" numCol="1" spcCol="0" rtlCol="0" fromWordArt="0" anchor="t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Metabolic pathway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Biosynthesis of secondary metabolite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lant hormone signal transduction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Biosynthesis of amino acid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arbon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henylpropan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MAPK signaling pathway − plant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ysteine and methionine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Glycerolipid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yanoamino acid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eroxisome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Galactose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entose and glucuronate interconversion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2−Oxocarboxylic acid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ircadian rhythm − plant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Flavon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Tyrosine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Fructose and mannose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henylalanine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Sphingolipid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henylalanine, tyrosine and tryptophan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Stilbenoid, diarylheptanoid and gingerol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Isoquinoline alkal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alpha−Linolenic acid metabolism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Tropane, piperidine and pyridine alkal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Cutin, suberine and wax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Glycosphingolipid biosynthesis − ganglio serie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Indole alkal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Isoflavonoid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indent="106606">
                    <a:lnSpc>
                      <a:spcPts val="636"/>
                    </a:lnSpc>
                  </a:pPr>
                  <a:r>
                    <a:rPr lang="en-US" sz="678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Flavone and flavonol biosynthesis</a:t>
                  </a:r>
                  <a:endParaRPr lang="zh-CN" altLang="en-US" sz="1017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53" name="图片 52">
                <a:extLst>
                  <a:ext uri="{FF2B5EF4-FFF2-40B4-BE49-F238E27FC236}">
                    <a16:creationId xmlns:a16="http://schemas.microsoft.com/office/drawing/2014/main" id="{25ACEE1C-41D1-4D83-AB16-74415982093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78" t="5155" r="9418" b="52616"/>
              <a:stretch/>
            </p:blipFill>
            <p:spPr bwMode="auto">
              <a:xfrm rot="5400000">
                <a:off x="713516" y="582286"/>
                <a:ext cx="2930642" cy="1765935"/>
              </a:xfrm>
              <a:prstGeom prst="rect">
                <a:avLst/>
              </a:prstGeom>
              <a:noFill/>
              <a:ln>
                <a:noFill/>
              </a:ln>
              <a:extLst>
                <a:ext uri="{53640926-AAD7-44D8-BBD7-CCE9431645EC}">
                  <a14:shadowObscured xmlns:a14="http://schemas.microsoft.com/office/drawing/2010/main"/>
                </a:ext>
              </a:extLst>
            </p:spPr>
          </p:pic>
        </p:grpSp>
        <p:grpSp>
          <p:nvGrpSpPr>
            <p:cNvPr id="58" name="组合 57">
              <a:extLst>
                <a:ext uri="{FF2B5EF4-FFF2-40B4-BE49-F238E27FC236}">
                  <a16:creationId xmlns:a16="http://schemas.microsoft.com/office/drawing/2014/main" id="{7034332A-0FCE-4D79-8627-EE7A83AD91F1}"/>
                </a:ext>
              </a:extLst>
            </p:cNvPr>
            <p:cNvGrpSpPr/>
            <p:nvPr/>
          </p:nvGrpSpPr>
          <p:grpSpPr>
            <a:xfrm>
              <a:off x="808990" y="1186180"/>
              <a:ext cx="7792085" cy="3848100"/>
              <a:chOff x="589933" y="1683867"/>
              <a:chExt cx="7792706" cy="3852864"/>
            </a:xfrm>
          </p:grpSpPr>
          <p:sp>
            <p:nvSpPr>
              <p:cNvPr id="59" name="矩形 58">
                <a:extLst>
                  <a:ext uri="{FF2B5EF4-FFF2-40B4-BE49-F238E27FC236}">
                    <a16:creationId xmlns:a16="http://schemas.microsoft.com/office/drawing/2014/main" id="{1FC3AFC0-E637-431C-B763-6AAE6183AFE7}"/>
                  </a:ext>
                </a:extLst>
              </p:cNvPr>
              <p:cNvSpPr/>
              <p:nvPr/>
            </p:nvSpPr>
            <p:spPr>
              <a:xfrm>
                <a:off x="589933" y="1683867"/>
                <a:ext cx="1252967" cy="138187"/>
              </a:xfrm>
              <a:prstGeom prst="rect">
                <a:avLst/>
              </a:prstGeom>
              <a:solidFill>
                <a:srgbClr val="4F81BD">
                  <a:alpha val="29000"/>
                </a:srgbClr>
              </a:solidFill>
              <a:ln w="25400" cap="flat" cmpd="sng" algn="ctr">
                <a:solidFill>
                  <a:srgbClr val="C00000"/>
                </a:solidFill>
                <a:prstDash val="dash"/>
              </a:ln>
              <a:effectLst/>
            </p:spPr>
            <p:txBody>
              <a:bodyPr rot="0" spcFirstLastPara="0" vert="horz" wrap="square" lIns="77528" tIns="38764" rIns="77528" bIns="3876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zh-CN" altLang="en-US" sz="1335"/>
              </a:p>
            </p:txBody>
          </p:sp>
          <p:sp>
            <p:nvSpPr>
              <p:cNvPr id="60" name="矩形 59">
                <a:extLst>
                  <a:ext uri="{FF2B5EF4-FFF2-40B4-BE49-F238E27FC236}">
                    <a16:creationId xmlns:a16="http://schemas.microsoft.com/office/drawing/2014/main" id="{51705EC9-9E7B-48FE-A31F-F652AECD05A1}"/>
                  </a:ext>
                </a:extLst>
              </p:cNvPr>
              <p:cNvSpPr/>
              <p:nvPr/>
            </p:nvSpPr>
            <p:spPr>
              <a:xfrm>
                <a:off x="4106003" y="1871882"/>
                <a:ext cx="1293495" cy="124581"/>
              </a:xfrm>
              <a:prstGeom prst="rect">
                <a:avLst/>
              </a:prstGeom>
              <a:solidFill>
                <a:srgbClr val="4F81BD">
                  <a:alpha val="29000"/>
                </a:srgbClr>
              </a:solidFill>
              <a:ln w="25400" cap="flat" cmpd="sng" algn="ctr">
                <a:solidFill>
                  <a:srgbClr val="C00000"/>
                </a:solidFill>
                <a:prstDash val="dash"/>
              </a:ln>
              <a:effectLst/>
            </p:spPr>
            <p:txBody>
              <a:bodyPr rot="0" spcFirstLastPara="0" vert="horz" wrap="square" lIns="77528" tIns="38764" rIns="77528" bIns="3876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zh-CN" altLang="en-US" sz="1335"/>
              </a:p>
            </p:txBody>
          </p:sp>
          <p:sp>
            <p:nvSpPr>
              <p:cNvPr id="61" name="矩形 60">
                <a:extLst>
                  <a:ext uri="{FF2B5EF4-FFF2-40B4-BE49-F238E27FC236}">
                    <a16:creationId xmlns:a16="http://schemas.microsoft.com/office/drawing/2014/main" id="{18E2F3DA-AFCC-491F-962E-84DE02C017EE}"/>
                  </a:ext>
                </a:extLst>
              </p:cNvPr>
              <p:cNvSpPr/>
              <p:nvPr/>
            </p:nvSpPr>
            <p:spPr>
              <a:xfrm>
                <a:off x="589933" y="2321946"/>
                <a:ext cx="1300597" cy="138187"/>
              </a:xfrm>
              <a:prstGeom prst="rect">
                <a:avLst/>
              </a:prstGeom>
              <a:solidFill>
                <a:srgbClr val="4F81BD">
                  <a:alpha val="29000"/>
                </a:srgbClr>
              </a:solidFill>
              <a:ln w="25400" cap="flat" cmpd="sng" algn="ctr">
                <a:solidFill>
                  <a:srgbClr val="C00000"/>
                </a:solidFill>
                <a:prstDash val="dash"/>
              </a:ln>
              <a:effectLst/>
            </p:spPr>
            <p:txBody>
              <a:bodyPr rot="0" spcFirstLastPara="0" vert="horz" wrap="square" lIns="77528" tIns="38764" rIns="77528" bIns="3876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zh-CN" altLang="en-US" sz="1335"/>
              </a:p>
            </p:txBody>
          </p:sp>
          <p:sp>
            <p:nvSpPr>
              <p:cNvPr id="62" name="矩形 61">
                <a:extLst>
                  <a:ext uri="{FF2B5EF4-FFF2-40B4-BE49-F238E27FC236}">
                    <a16:creationId xmlns:a16="http://schemas.microsoft.com/office/drawing/2014/main" id="{78D19A6A-3849-4046-8FF9-76C6553C5B59}"/>
                  </a:ext>
                </a:extLst>
              </p:cNvPr>
              <p:cNvSpPr/>
              <p:nvPr/>
            </p:nvSpPr>
            <p:spPr>
              <a:xfrm>
                <a:off x="4106001" y="2423231"/>
                <a:ext cx="1293495" cy="124581"/>
              </a:xfrm>
              <a:prstGeom prst="rect">
                <a:avLst/>
              </a:prstGeom>
              <a:solidFill>
                <a:srgbClr val="4F81BD">
                  <a:alpha val="29000"/>
                </a:srgbClr>
              </a:solidFill>
              <a:ln w="25400" cap="flat" cmpd="sng" algn="ctr">
                <a:solidFill>
                  <a:srgbClr val="C00000"/>
                </a:solidFill>
                <a:prstDash val="dash"/>
              </a:ln>
              <a:effectLst/>
            </p:spPr>
            <p:txBody>
              <a:bodyPr rot="0" spcFirstLastPara="0" vert="horz" wrap="square" lIns="77528" tIns="38764" rIns="77528" bIns="3876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zh-CN" altLang="en-US" sz="1335"/>
              </a:p>
            </p:txBody>
          </p:sp>
          <p:sp>
            <p:nvSpPr>
              <p:cNvPr id="63" name="矩形 62">
                <a:extLst>
                  <a:ext uri="{FF2B5EF4-FFF2-40B4-BE49-F238E27FC236}">
                    <a16:creationId xmlns:a16="http://schemas.microsoft.com/office/drawing/2014/main" id="{458A152A-7EA3-4B7A-9FBF-E7E7FBD21E13}"/>
                  </a:ext>
                </a:extLst>
              </p:cNvPr>
              <p:cNvSpPr/>
              <p:nvPr/>
            </p:nvSpPr>
            <p:spPr>
              <a:xfrm>
                <a:off x="4109544" y="4864210"/>
                <a:ext cx="1293495" cy="124581"/>
              </a:xfrm>
              <a:prstGeom prst="rect">
                <a:avLst/>
              </a:prstGeom>
              <a:solidFill>
                <a:srgbClr val="4F81BD">
                  <a:alpha val="29000"/>
                </a:srgbClr>
              </a:solidFill>
              <a:ln w="25400" cap="flat" cmpd="sng" algn="ctr">
                <a:solidFill>
                  <a:srgbClr val="C00000"/>
                </a:solidFill>
                <a:prstDash val="dash"/>
              </a:ln>
              <a:effectLst/>
            </p:spPr>
            <p:txBody>
              <a:bodyPr rot="0" spcFirstLastPara="0" vert="horz" wrap="square" lIns="77528" tIns="38764" rIns="77528" bIns="3876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zh-CN" altLang="en-US" sz="1335"/>
              </a:p>
            </p:txBody>
          </p:sp>
          <p:sp>
            <p:nvSpPr>
              <p:cNvPr id="64" name="矩形 63">
                <a:extLst>
                  <a:ext uri="{FF2B5EF4-FFF2-40B4-BE49-F238E27FC236}">
                    <a16:creationId xmlns:a16="http://schemas.microsoft.com/office/drawing/2014/main" id="{ED1CA45A-0D7D-4585-86B8-D998CDEA6DEC}"/>
                  </a:ext>
                </a:extLst>
              </p:cNvPr>
              <p:cNvSpPr/>
              <p:nvPr/>
            </p:nvSpPr>
            <p:spPr>
              <a:xfrm>
                <a:off x="4109544" y="5412150"/>
                <a:ext cx="1293495" cy="124581"/>
              </a:xfrm>
              <a:prstGeom prst="rect">
                <a:avLst/>
              </a:prstGeom>
              <a:solidFill>
                <a:srgbClr val="4F81BD">
                  <a:alpha val="29000"/>
                </a:srgbClr>
              </a:solidFill>
              <a:ln w="25400" cap="flat" cmpd="sng" algn="ctr">
                <a:solidFill>
                  <a:srgbClr val="C00000"/>
                </a:solidFill>
                <a:prstDash val="dash"/>
              </a:ln>
              <a:effectLst/>
            </p:spPr>
            <p:txBody>
              <a:bodyPr rot="0" spcFirstLastPara="0" vert="horz" wrap="square" lIns="77528" tIns="38764" rIns="77528" bIns="3876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zh-CN" altLang="en-US" sz="1335"/>
              </a:p>
            </p:txBody>
          </p:sp>
          <p:sp>
            <p:nvSpPr>
              <p:cNvPr id="65" name="矩形 64">
                <a:extLst>
                  <a:ext uri="{FF2B5EF4-FFF2-40B4-BE49-F238E27FC236}">
                    <a16:creationId xmlns:a16="http://schemas.microsoft.com/office/drawing/2014/main" id="{9044B17B-023D-4FDF-B756-F83CD3FBCFCC}"/>
                  </a:ext>
                </a:extLst>
              </p:cNvPr>
              <p:cNvSpPr/>
              <p:nvPr/>
            </p:nvSpPr>
            <p:spPr>
              <a:xfrm>
                <a:off x="637563" y="4684137"/>
                <a:ext cx="1252967" cy="138187"/>
              </a:xfrm>
              <a:prstGeom prst="rect">
                <a:avLst/>
              </a:prstGeom>
              <a:solidFill>
                <a:srgbClr val="4F81BD">
                  <a:alpha val="29000"/>
                </a:srgbClr>
              </a:solidFill>
              <a:ln w="25400" cap="flat" cmpd="sng" algn="ctr">
                <a:solidFill>
                  <a:srgbClr val="C00000"/>
                </a:solidFill>
                <a:prstDash val="dash"/>
              </a:ln>
              <a:effectLst/>
            </p:spPr>
            <p:txBody>
              <a:bodyPr rot="0" spcFirstLastPara="0" vert="horz" wrap="square" lIns="77528" tIns="38764" rIns="77528" bIns="3876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zh-CN" altLang="en-US" sz="1335"/>
              </a:p>
            </p:txBody>
          </p:sp>
          <p:sp>
            <p:nvSpPr>
              <p:cNvPr id="66" name="矩形 65">
                <a:extLst>
                  <a:ext uri="{FF2B5EF4-FFF2-40B4-BE49-F238E27FC236}">
                    <a16:creationId xmlns:a16="http://schemas.microsoft.com/office/drawing/2014/main" id="{EFEE7BFE-3440-4A73-9A8C-A03824D928E2}"/>
                  </a:ext>
                </a:extLst>
              </p:cNvPr>
              <p:cNvSpPr/>
              <p:nvPr/>
            </p:nvSpPr>
            <p:spPr>
              <a:xfrm>
                <a:off x="637563" y="5322216"/>
                <a:ext cx="1300597" cy="138187"/>
              </a:xfrm>
              <a:prstGeom prst="rect">
                <a:avLst/>
              </a:prstGeom>
              <a:solidFill>
                <a:srgbClr val="4F81BD">
                  <a:alpha val="29000"/>
                </a:srgbClr>
              </a:solidFill>
              <a:ln w="25400" cap="flat" cmpd="sng" algn="ctr">
                <a:solidFill>
                  <a:srgbClr val="C00000"/>
                </a:solidFill>
                <a:prstDash val="dash"/>
              </a:ln>
              <a:effectLst/>
            </p:spPr>
            <p:txBody>
              <a:bodyPr rot="0" spcFirstLastPara="0" vert="horz" wrap="square" lIns="77528" tIns="38764" rIns="77528" bIns="3876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zh-CN" altLang="en-US" sz="1335"/>
              </a:p>
            </p:txBody>
          </p:sp>
          <p:sp>
            <p:nvSpPr>
              <p:cNvPr id="67" name="矩形 66">
                <a:extLst>
                  <a:ext uri="{FF2B5EF4-FFF2-40B4-BE49-F238E27FC236}">
                    <a16:creationId xmlns:a16="http://schemas.microsoft.com/office/drawing/2014/main" id="{3647A288-F3ED-4BDB-A055-A0D2319DC857}"/>
                  </a:ext>
                </a:extLst>
              </p:cNvPr>
              <p:cNvSpPr/>
              <p:nvPr/>
            </p:nvSpPr>
            <p:spPr>
              <a:xfrm>
                <a:off x="7142538" y="2076162"/>
                <a:ext cx="1239982" cy="128895"/>
              </a:xfrm>
              <a:prstGeom prst="rect">
                <a:avLst/>
              </a:prstGeom>
              <a:solidFill>
                <a:srgbClr val="4F81BD">
                  <a:alpha val="29000"/>
                </a:srgbClr>
              </a:solidFill>
              <a:ln w="25400" cap="flat" cmpd="sng" algn="ctr">
                <a:solidFill>
                  <a:srgbClr val="C00000"/>
                </a:solidFill>
                <a:prstDash val="dash"/>
              </a:ln>
              <a:effectLst/>
            </p:spPr>
            <p:txBody>
              <a:bodyPr rot="0" spcFirstLastPara="0" vert="horz" wrap="square" lIns="77528" tIns="38764" rIns="77528" bIns="3876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zh-CN" altLang="en-US" sz="1335"/>
              </a:p>
            </p:txBody>
          </p:sp>
          <p:sp>
            <p:nvSpPr>
              <p:cNvPr id="68" name="矩形 67">
                <a:extLst>
                  <a:ext uri="{FF2B5EF4-FFF2-40B4-BE49-F238E27FC236}">
                    <a16:creationId xmlns:a16="http://schemas.microsoft.com/office/drawing/2014/main" id="{7FE736EC-C897-4ED2-96F8-10725DFB2584}"/>
                  </a:ext>
                </a:extLst>
              </p:cNvPr>
              <p:cNvSpPr/>
              <p:nvPr/>
            </p:nvSpPr>
            <p:spPr>
              <a:xfrm>
                <a:off x="7142657" y="3023418"/>
                <a:ext cx="1239982" cy="128895"/>
              </a:xfrm>
              <a:prstGeom prst="rect">
                <a:avLst/>
              </a:prstGeom>
              <a:solidFill>
                <a:srgbClr val="4F81BD">
                  <a:alpha val="29000"/>
                </a:srgbClr>
              </a:solidFill>
              <a:ln w="25400" cap="flat" cmpd="sng" algn="ctr">
                <a:solidFill>
                  <a:srgbClr val="C00000"/>
                </a:solidFill>
                <a:prstDash val="dash"/>
              </a:ln>
              <a:effectLst/>
            </p:spPr>
            <p:txBody>
              <a:bodyPr rot="0" spcFirstLastPara="0" vert="horz" wrap="square" lIns="77528" tIns="38764" rIns="77528" bIns="3876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zh-CN" altLang="en-US" sz="1335"/>
              </a:p>
            </p:txBody>
          </p:sp>
        </p:grpSp>
        <p:cxnSp>
          <p:nvCxnSpPr>
            <p:cNvPr id="69" name="直接连接符 68">
              <a:extLst>
                <a:ext uri="{FF2B5EF4-FFF2-40B4-BE49-F238E27FC236}">
                  <a16:creationId xmlns:a16="http://schemas.microsoft.com/office/drawing/2014/main" id="{07F6264A-8C69-403C-AE68-F8A64D25EC53}"/>
                </a:ext>
              </a:extLst>
            </p:cNvPr>
            <p:cNvCxnSpPr/>
            <p:nvPr/>
          </p:nvCxnSpPr>
          <p:spPr>
            <a:xfrm>
              <a:off x="664210" y="1251585"/>
              <a:ext cx="0" cy="570103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Rectangle 76">
              <a:extLst>
                <a:ext uri="{FF2B5EF4-FFF2-40B4-BE49-F238E27FC236}">
                  <a16:creationId xmlns:a16="http://schemas.microsoft.com/office/drawing/2014/main" id="{2D4A5D5F-85D8-4769-87FA-EF8F2143C0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0" y="61281"/>
              <a:ext cx="184742" cy="3346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77528" tIns="38764" rIns="77528" bIns="38764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zh-CN" altLang="en-US" sz="1335"/>
            </a:p>
          </p:txBody>
        </p:sp>
        <p:sp>
          <p:nvSpPr>
            <p:cNvPr id="71" name="Rectangle 84">
              <a:extLst>
                <a:ext uri="{FF2B5EF4-FFF2-40B4-BE49-F238E27FC236}">
                  <a16:creationId xmlns:a16="http://schemas.microsoft.com/office/drawing/2014/main" id="{01D53930-33D6-4926-91BC-AFB7410857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0" y="289881"/>
              <a:ext cx="184742" cy="33463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77528" tIns="38764" rIns="77528" bIns="38764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zh-CN" altLang="en-US" sz="1335"/>
            </a:p>
          </p:txBody>
        </p:sp>
        <p:grpSp>
          <p:nvGrpSpPr>
            <p:cNvPr id="82" name="组合 81">
              <a:extLst>
                <a:ext uri="{FF2B5EF4-FFF2-40B4-BE49-F238E27FC236}">
                  <a16:creationId xmlns:a16="http://schemas.microsoft.com/office/drawing/2014/main" id="{076883B2-467A-4072-8C08-E0FC66AA85A8}"/>
                </a:ext>
              </a:extLst>
            </p:cNvPr>
            <p:cNvGrpSpPr/>
            <p:nvPr/>
          </p:nvGrpSpPr>
          <p:grpSpPr>
            <a:xfrm>
              <a:off x="820615" y="7540873"/>
              <a:ext cx="8801100" cy="5220335"/>
              <a:chOff x="0" y="1"/>
              <a:chExt cx="10227911" cy="3978764"/>
            </a:xfrm>
          </p:grpSpPr>
          <p:graphicFrame>
            <p:nvGraphicFramePr>
              <p:cNvPr id="83" name="图表 82">
                <a:extLst>
                  <a:ext uri="{FF2B5EF4-FFF2-40B4-BE49-F238E27FC236}">
                    <a16:creationId xmlns:a16="http://schemas.microsoft.com/office/drawing/2014/main" id="{71324D16-E581-43FE-9ACF-4DABED47C29D}"/>
                  </a:ext>
                </a:extLst>
              </p:cNvPr>
              <p:cNvGraphicFramePr/>
              <p:nvPr/>
            </p:nvGraphicFramePr>
            <p:xfrm>
              <a:off x="0" y="32654"/>
              <a:ext cx="4016829" cy="167455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graphicFrame>
            <p:nvGraphicFramePr>
              <p:cNvPr id="84" name="图表 83">
                <a:extLst>
                  <a:ext uri="{FF2B5EF4-FFF2-40B4-BE49-F238E27FC236}">
                    <a16:creationId xmlns:a16="http://schemas.microsoft.com/office/drawing/2014/main" id="{9B4BBB44-A1B6-4444-B322-C85CB44C68B2}"/>
                  </a:ext>
                </a:extLst>
              </p:cNvPr>
              <p:cNvGraphicFramePr/>
              <p:nvPr/>
            </p:nvGraphicFramePr>
            <p:xfrm>
              <a:off x="381000" y="1752789"/>
              <a:ext cx="3635829" cy="191007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  <p:graphicFrame>
            <p:nvGraphicFramePr>
              <p:cNvPr id="85" name="图表 84">
                <a:extLst>
                  <a:ext uri="{FF2B5EF4-FFF2-40B4-BE49-F238E27FC236}">
                    <a16:creationId xmlns:a16="http://schemas.microsoft.com/office/drawing/2014/main" id="{0C923780-AF50-464C-9732-285508F6188C}"/>
                  </a:ext>
                </a:extLst>
              </p:cNvPr>
              <p:cNvGraphicFramePr/>
              <p:nvPr/>
            </p:nvGraphicFramePr>
            <p:xfrm>
              <a:off x="3570514" y="1"/>
              <a:ext cx="3614057" cy="184761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0"/>
              </a:graphicData>
            </a:graphic>
          </p:graphicFrame>
          <p:graphicFrame>
            <p:nvGraphicFramePr>
              <p:cNvPr id="86" name="图表 85">
                <a:extLst>
                  <a:ext uri="{FF2B5EF4-FFF2-40B4-BE49-F238E27FC236}">
                    <a16:creationId xmlns:a16="http://schemas.microsoft.com/office/drawing/2014/main" id="{D67E5B68-CE17-4BE6-A126-EF0038B9390F}"/>
                  </a:ext>
                </a:extLst>
              </p:cNvPr>
              <p:cNvGraphicFramePr/>
              <p:nvPr/>
            </p:nvGraphicFramePr>
            <p:xfrm>
              <a:off x="3282513" y="1707222"/>
              <a:ext cx="3907971" cy="205507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1"/>
              </a:graphicData>
            </a:graphic>
          </p:graphicFrame>
          <p:graphicFrame>
            <p:nvGraphicFramePr>
              <p:cNvPr id="87" name="图表 86">
                <a:extLst>
                  <a:ext uri="{FF2B5EF4-FFF2-40B4-BE49-F238E27FC236}">
                    <a16:creationId xmlns:a16="http://schemas.microsoft.com/office/drawing/2014/main" id="{06F26940-001F-4F42-B480-F98162F073A5}"/>
                  </a:ext>
                </a:extLst>
              </p:cNvPr>
              <p:cNvGraphicFramePr/>
              <p:nvPr/>
            </p:nvGraphicFramePr>
            <p:xfrm>
              <a:off x="6400529" y="2"/>
              <a:ext cx="3712029" cy="158526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2"/>
              </a:graphicData>
            </a:graphic>
          </p:graphicFrame>
          <p:graphicFrame>
            <p:nvGraphicFramePr>
              <p:cNvPr id="88" name="图表 87">
                <a:extLst>
                  <a:ext uri="{FF2B5EF4-FFF2-40B4-BE49-F238E27FC236}">
                    <a16:creationId xmlns:a16="http://schemas.microsoft.com/office/drawing/2014/main" id="{C0470792-29A1-43A3-9871-0A0C30BAEB51}"/>
                  </a:ext>
                </a:extLst>
              </p:cNvPr>
              <p:cNvGraphicFramePr/>
              <p:nvPr/>
            </p:nvGraphicFramePr>
            <p:xfrm>
              <a:off x="6864226" y="1404615"/>
              <a:ext cx="3363685" cy="257415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3"/>
              </a:graphicData>
            </a:graphic>
          </p:graphicFrame>
        </p:grpSp>
        <p:grpSp>
          <p:nvGrpSpPr>
            <p:cNvPr id="91" name="组合 90">
              <a:extLst>
                <a:ext uri="{FF2B5EF4-FFF2-40B4-BE49-F238E27FC236}">
                  <a16:creationId xmlns:a16="http://schemas.microsoft.com/office/drawing/2014/main" id="{8F672A4F-76CF-428F-A365-FFE9E8AD3D53}"/>
                </a:ext>
              </a:extLst>
            </p:cNvPr>
            <p:cNvGrpSpPr/>
            <p:nvPr/>
          </p:nvGrpSpPr>
          <p:grpSpPr>
            <a:xfrm>
              <a:off x="1277815" y="10305028"/>
              <a:ext cx="6809740" cy="705485"/>
              <a:chOff x="637563" y="1694576"/>
              <a:chExt cx="6810272" cy="706290"/>
            </a:xfrm>
          </p:grpSpPr>
          <p:sp>
            <p:nvSpPr>
              <p:cNvPr id="92" name="矩形 91">
                <a:extLst>
                  <a:ext uri="{FF2B5EF4-FFF2-40B4-BE49-F238E27FC236}">
                    <a16:creationId xmlns:a16="http://schemas.microsoft.com/office/drawing/2014/main" id="{AB82E78D-7270-4AFF-BCDF-54F421FF4A0F}"/>
                  </a:ext>
                </a:extLst>
              </p:cNvPr>
              <p:cNvSpPr/>
              <p:nvPr/>
            </p:nvSpPr>
            <p:spPr>
              <a:xfrm>
                <a:off x="637563" y="1694576"/>
                <a:ext cx="1300597" cy="368300"/>
              </a:xfrm>
              <a:prstGeom prst="rect">
                <a:avLst/>
              </a:prstGeom>
              <a:solidFill>
                <a:srgbClr val="4F81BD">
                  <a:alpha val="29000"/>
                </a:srgbClr>
              </a:solidFill>
              <a:ln w="25400" cap="flat" cmpd="sng" algn="ctr">
                <a:solidFill>
                  <a:srgbClr val="C00000"/>
                </a:solidFill>
                <a:prstDash val="dash"/>
              </a:ln>
              <a:effectLst/>
            </p:spPr>
            <p:txBody>
              <a:bodyPr rot="0" spcFirstLastPara="0" vert="horz" wrap="square" lIns="77528" tIns="38764" rIns="77528" bIns="3876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zh-CN" altLang="en-US" sz="1335"/>
              </a:p>
            </p:txBody>
          </p:sp>
          <p:sp>
            <p:nvSpPr>
              <p:cNvPr id="93" name="矩形 92">
                <a:extLst>
                  <a:ext uri="{FF2B5EF4-FFF2-40B4-BE49-F238E27FC236}">
                    <a16:creationId xmlns:a16="http://schemas.microsoft.com/office/drawing/2014/main" id="{9EF12674-3102-4ECA-AC18-5D5BA312ED55}"/>
                  </a:ext>
                </a:extLst>
              </p:cNvPr>
              <p:cNvSpPr/>
              <p:nvPr/>
            </p:nvSpPr>
            <p:spPr>
              <a:xfrm>
                <a:off x="3381346" y="2065871"/>
                <a:ext cx="1293495" cy="334995"/>
              </a:xfrm>
              <a:prstGeom prst="rect">
                <a:avLst/>
              </a:prstGeom>
              <a:solidFill>
                <a:srgbClr val="4F81BD">
                  <a:alpha val="29000"/>
                </a:srgbClr>
              </a:solidFill>
              <a:ln w="25400" cap="flat" cmpd="sng" algn="ctr">
                <a:solidFill>
                  <a:srgbClr val="C00000"/>
                </a:solidFill>
                <a:prstDash val="dash"/>
              </a:ln>
              <a:effectLst/>
            </p:spPr>
            <p:txBody>
              <a:bodyPr rot="0" spcFirstLastPara="0" vert="horz" wrap="square" lIns="77528" tIns="38764" rIns="77528" bIns="3876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zh-CN" altLang="en-US" sz="1335"/>
              </a:p>
            </p:txBody>
          </p:sp>
          <p:sp>
            <p:nvSpPr>
              <p:cNvPr id="94" name="矩形 93">
                <a:extLst>
                  <a:ext uri="{FF2B5EF4-FFF2-40B4-BE49-F238E27FC236}">
                    <a16:creationId xmlns:a16="http://schemas.microsoft.com/office/drawing/2014/main" id="{F99322DD-64F8-4E92-A1E4-EBD39BF2DB86}"/>
                  </a:ext>
                </a:extLst>
              </p:cNvPr>
              <p:cNvSpPr/>
              <p:nvPr/>
            </p:nvSpPr>
            <p:spPr>
              <a:xfrm>
                <a:off x="6207853" y="1804287"/>
                <a:ext cx="1239982" cy="258368"/>
              </a:xfrm>
              <a:prstGeom prst="rect">
                <a:avLst/>
              </a:prstGeom>
              <a:solidFill>
                <a:srgbClr val="4F81BD">
                  <a:alpha val="29000"/>
                </a:srgbClr>
              </a:solidFill>
              <a:ln w="25400" cap="flat" cmpd="sng" algn="ctr">
                <a:solidFill>
                  <a:srgbClr val="C00000"/>
                </a:solidFill>
                <a:prstDash val="dash"/>
              </a:ln>
              <a:effectLst/>
            </p:spPr>
            <p:txBody>
              <a:bodyPr rot="0" spcFirstLastPara="0" vert="horz" wrap="square" lIns="77528" tIns="38764" rIns="77528" bIns="38764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endParaRPr lang="zh-CN" altLang="en-US" sz="1335"/>
              </a:p>
            </p:txBody>
          </p:sp>
        </p:grpSp>
        <p:sp>
          <p:nvSpPr>
            <p:cNvPr id="95" name="文本框 244">
              <a:extLst>
                <a:ext uri="{FF2B5EF4-FFF2-40B4-BE49-F238E27FC236}">
                  <a16:creationId xmlns:a16="http://schemas.microsoft.com/office/drawing/2014/main" id="{8C7E9296-4C9B-4665-B240-8EE0B1E17CF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18492" y="8752953"/>
              <a:ext cx="342900" cy="381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6350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38764" rIns="0" bIns="38764" numCol="1" anchor="t" anchorCtr="0" compatLnSpc="1">
              <a:prstTxWarp prst="textNoShape">
                <a:avLst/>
              </a:prstTxWarp>
            </a:bodyPr>
            <a:lstStyle/>
            <a:p>
              <a:pPr indent="107683" defTabSz="775320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zh-CN" sz="1017" b="1">
                  <a:latin typeface="Arial" panose="020B0604020202020204" pitchFamily="34" charset="0"/>
                  <a:ea typeface="宋体" panose="02010600030101010101" pitchFamily="2" charset="-122"/>
                  <a:cs typeface="Times New Roman" panose="02020603050405020304" pitchFamily="18" charset="0"/>
                </a:rPr>
                <a:t>b</a:t>
              </a:r>
              <a:endParaRPr lang="en-US" altLang="zh-CN" sz="1526">
                <a:latin typeface="Arial" panose="020B0604020202020204" pitchFamily="34" charset="0"/>
              </a:endParaRPr>
            </a:p>
          </p:txBody>
        </p:sp>
        <p:cxnSp>
          <p:nvCxnSpPr>
            <p:cNvPr id="96" name="直接连接符 95">
              <a:extLst>
                <a:ext uri="{FF2B5EF4-FFF2-40B4-BE49-F238E27FC236}">
                  <a16:creationId xmlns:a16="http://schemas.microsoft.com/office/drawing/2014/main" id="{BBCC9D17-4828-4FAA-9C66-2C3E73FF63A8}"/>
                </a:ext>
              </a:extLst>
            </p:cNvPr>
            <p:cNvCxnSpPr/>
            <p:nvPr/>
          </p:nvCxnSpPr>
          <p:spPr>
            <a:xfrm>
              <a:off x="668215" y="7165588"/>
              <a:ext cx="0" cy="5316855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Rectangle 110">
              <a:extLst>
                <a:ext uri="{FF2B5EF4-FFF2-40B4-BE49-F238E27FC236}">
                  <a16:creationId xmlns:a16="http://schemas.microsoft.com/office/drawing/2014/main" id="{E27E40FE-6E01-40AD-AAA9-E651D6259E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46185" y="5389622"/>
              <a:ext cx="1846155" cy="25499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775037" tIns="968796" rIns="775037" bIns="968796" numCol="1" anchor="ctr" anchorCtr="0" compatLnSpc="1">
              <a:prstTxWarp prst="textNoShape">
                <a:avLst/>
              </a:prstTxWarp>
              <a:spAutoFit/>
            </a:bodyPr>
            <a:lstStyle/>
            <a:p>
              <a:endParaRPr lang="zh-CN" altLang="en-US" sz="1335"/>
            </a:p>
          </p:txBody>
        </p:sp>
        <p:sp>
          <p:nvSpPr>
            <p:cNvPr id="98" name="Rectangle 114">
              <a:extLst>
                <a:ext uri="{FF2B5EF4-FFF2-40B4-BE49-F238E27FC236}">
                  <a16:creationId xmlns:a16="http://schemas.microsoft.com/office/drawing/2014/main" id="{EAF8F1C8-76A8-4BA8-8BE8-AAE1AB3CAA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-246185" y="6523933"/>
              <a:ext cx="184742" cy="73848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none" lIns="77528" tIns="38764" rIns="77528" bIns="38764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defTabSz="775320" eaLnBrk="0" fontAlgn="base" hangingPunct="0">
                <a:spcBef>
                  <a:spcPct val="0"/>
                </a:spcBef>
                <a:spcAft>
                  <a:spcPct val="0"/>
                </a:spcAft>
              </a:pPr>
              <a:endParaRPr lang="en-US" altLang="zh-CN" sz="1017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  <a:p>
              <a:pPr defTabSz="775320" eaLnBrk="0" fontAlgn="base" hangingPunct="0">
                <a:spcBef>
                  <a:spcPct val="0"/>
                </a:spcBef>
                <a:spcAft>
                  <a:spcPct val="0"/>
                </a:spcAft>
              </a:pPr>
              <a:br>
                <a:rPr lang="en-US" altLang="zh-CN" sz="1017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</a:br>
              <a:endParaRPr lang="en-US" altLang="zh-CN" sz="1526">
                <a:latin typeface="Arial" panose="020B0604020202020204" pitchFamily="34" charset="0"/>
              </a:endParaRPr>
            </a:p>
          </p:txBody>
        </p:sp>
      </p:grpSp>
      <p:sp>
        <p:nvSpPr>
          <p:cNvPr id="5" name="文本框 4">
            <a:extLst>
              <a:ext uri="{FF2B5EF4-FFF2-40B4-BE49-F238E27FC236}">
                <a16:creationId xmlns:a16="http://schemas.microsoft.com/office/drawing/2014/main" id="{E18E9EF7-C778-47DA-AED3-9CFF3B1EFFF4}"/>
              </a:ext>
            </a:extLst>
          </p:cNvPr>
          <p:cNvSpPr txBox="1"/>
          <p:nvPr/>
        </p:nvSpPr>
        <p:spPr>
          <a:xfrm>
            <a:off x="377232" y="258108"/>
            <a:ext cx="42055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 Fig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8726869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601</Words>
  <Application>Microsoft Office PowerPoint</Application>
  <PresentationFormat>自定义</PresentationFormat>
  <Paragraphs>17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Xiaobai</dc:creator>
  <cp:lastModifiedBy>Li Xiaobai</cp:lastModifiedBy>
  <cp:revision>4</cp:revision>
  <dcterms:created xsi:type="dcterms:W3CDTF">2021-05-07T15:42:38Z</dcterms:created>
  <dcterms:modified xsi:type="dcterms:W3CDTF">2021-06-20T07:41:40Z</dcterms:modified>
</cp:coreProperties>
</file>